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4660"/>
  </p:normalViewPr>
  <p:slideViewPr>
    <p:cSldViewPr>
      <p:cViewPr varScale="1">
        <p:scale>
          <a:sx n="74" d="100"/>
          <a:sy n="74" d="100"/>
        </p:scale>
        <p:origin x="2346" y="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dell%20pc\Dropbox\Prove%20Magnololo%20e%20sinergici\Final%20histogram%20_magn%20paper\Honokiol%20Diacetato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3590206552439752E-2"/>
          <c:y val="2.2753128555176336E-2"/>
          <c:w val="0.83181102362204729"/>
          <c:h val="0.83845278725824801"/>
        </c:manualLayout>
      </c:layout>
      <c:barChart>
        <c:barDir val="col"/>
        <c:grouping val="clustered"/>
        <c:varyColors val="0"/>
        <c:ser>
          <c:idx val="2"/>
          <c:order val="0"/>
          <c:tx>
            <c:strRef>
              <c:f>Graph!$D$22</c:f>
              <c:strCache>
                <c:ptCount val="1"/>
                <c:pt idx="0">
                  <c:v>100 µg/mL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raph!$G$23:$G$37</c:f>
                <c:numCache>
                  <c:formatCode>General</c:formatCode>
                  <c:ptCount val="15"/>
                  <c:pt idx="0">
                    <c:v>6.1493751564540853</c:v>
                  </c:pt>
                  <c:pt idx="1">
                    <c:v>5.2486388108147812</c:v>
                  </c:pt>
                  <c:pt idx="2">
                    <c:v>2.7010538909456123</c:v>
                  </c:pt>
                  <c:pt idx="3">
                    <c:v>9.515554378271661</c:v>
                  </c:pt>
                  <c:pt idx="4">
                    <c:v>2.1430335024428806</c:v>
                  </c:pt>
                  <c:pt idx="5">
                    <c:v>0</c:v>
                  </c:pt>
                  <c:pt idx="6">
                    <c:v>0.26646935501058328</c:v>
                  </c:pt>
                  <c:pt idx="7">
                    <c:v>0</c:v>
                  </c:pt>
                  <c:pt idx="8">
                    <c:v>1.4899361785538716</c:v>
                  </c:pt>
                  <c:pt idx="9">
                    <c:v>4.8112522432468703</c:v>
                  </c:pt>
                  <c:pt idx="10">
                    <c:v>1.7564889142012314</c:v>
                  </c:pt>
                  <c:pt idx="11">
                    <c:v>5.7575757575757534</c:v>
                  </c:pt>
                  <c:pt idx="12">
                    <c:v>1.9245008972987498</c:v>
                  </c:pt>
                  <c:pt idx="13">
                    <c:v>0.26646935501058328</c:v>
                  </c:pt>
                  <c:pt idx="14">
                    <c:v>5.020437123388044</c:v>
                  </c:pt>
                </c:numCache>
              </c:numRef>
            </c:plus>
            <c:minus>
              <c:numRef>
                <c:f>Graph!$G$23:$G$37</c:f>
                <c:numCache>
                  <c:formatCode>General</c:formatCode>
                  <c:ptCount val="15"/>
                  <c:pt idx="0">
                    <c:v>6.1493751564540853</c:v>
                  </c:pt>
                  <c:pt idx="1">
                    <c:v>5.2486388108147812</c:v>
                  </c:pt>
                  <c:pt idx="2">
                    <c:v>2.7010538909456123</c:v>
                  </c:pt>
                  <c:pt idx="3">
                    <c:v>9.515554378271661</c:v>
                  </c:pt>
                  <c:pt idx="4">
                    <c:v>2.1430335024428806</c:v>
                  </c:pt>
                  <c:pt idx="5">
                    <c:v>0</c:v>
                  </c:pt>
                  <c:pt idx="6">
                    <c:v>0.26646935501058328</c:v>
                  </c:pt>
                  <c:pt idx="7">
                    <c:v>0</c:v>
                  </c:pt>
                  <c:pt idx="8">
                    <c:v>1.4899361785538716</c:v>
                  </c:pt>
                  <c:pt idx="9">
                    <c:v>4.8112522432468703</c:v>
                  </c:pt>
                  <c:pt idx="10">
                    <c:v>1.7564889142012314</c:v>
                  </c:pt>
                  <c:pt idx="11">
                    <c:v>5.7575757575757534</c:v>
                  </c:pt>
                  <c:pt idx="12">
                    <c:v>1.9245008972987498</c:v>
                  </c:pt>
                  <c:pt idx="13">
                    <c:v>0.26646935501058328</c:v>
                  </c:pt>
                  <c:pt idx="14">
                    <c:v>5.020437123388044</c:v>
                  </c:pt>
                </c:numCache>
              </c:numRef>
            </c:minus>
          </c:errBars>
          <c:cat>
            <c:strRef>
              <c:f>Graph!$C$23:$C$37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D$23:$D$37</c:f>
              <c:numCache>
                <c:formatCode>0.0</c:formatCode>
                <c:ptCount val="15"/>
                <c:pt idx="0">
                  <c:v>81.843434343434353</c:v>
                </c:pt>
                <c:pt idx="1">
                  <c:v>65.180375180375179</c:v>
                </c:pt>
                <c:pt idx="2">
                  <c:v>70.955165692007782</c:v>
                </c:pt>
                <c:pt idx="3">
                  <c:v>83.78191856452726</c:v>
                </c:pt>
                <c:pt idx="4">
                  <c:v>62.166666666666664</c:v>
                </c:pt>
                <c:pt idx="5">
                  <c:v>60.919540229885058</c:v>
                </c:pt>
                <c:pt idx="6">
                  <c:v>80.512820512820511</c:v>
                </c:pt>
                <c:pt idx="7">
                  <c:v>80</c:v>
                </c:pt>
                <c:pt idx="8">
                  <c:v>62.652329749103949</c:v>
                </c:pt>
                <c:pt idx="9">
                  <c:v>78.562801932367151</c:v>
                </c:pt>
                <c:pt idx="10">
                  <c:v>65.035273368606695</c:v>
                </c:pt>
                <c:pt idx="11">
                  <c:v>68.8888888888889</c:v>
                </c:pt>
                <c:pt idx="12">
                  <c:v>61.111111111111114</c:v>
                </c:pt>
                <c:pt idx="13">
                  <c:v>63.692307692307701</c:v>
                </c:pt>
                <c:pt idx="14">
                  <c:v>69.56521739130435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1E7D-4267-8323-3EFC8859AE37}"/>
            </c:ext>
          </c:extLst>
        </c:ser>
        <c:ser>
          <c:idx val="6"/>
          <c:order val="1"/>
          <c:tx>
            <c:strRef>
              <c:f>Graph!$F$22</c:f>
              <c:strCache>
                <c:ptCount val="1"/>
                <c:pt idx="0">
                  <c:v>50 µg/mL</c:v>
                </c:pt>
              </c:strCache>
            </c:strRef>
          </c:tx>
          <c:spPr>
            <a:solidFill>
              <a:srgbClr val="D628A8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K$23:$K$37</c:f>
                <c:numCache>
                  <c:formatCode>General</c:formatCode>
                  <c:ptCount val="15"/>
                  <c:pt idx="0">
                    <c:v>6.1493751564540853</c:v>
                  </c:pt>
                  <c:pt idx="1">
                    <c:v>4.5471720798235884</c:v>
                  </c:pt>
                  <c:pt idx="2">
                    <c:v>3.2075014954979215</c:v>
                  </c:pt>
                  <c:pt idx="3">
                    <c:v>7.7697241195291253</c:v>
                  </c:pt>
                  <c:pt idx="4">
                    <c:v>3.8345408726083199</c:v>
                  </c:pt>
                  <c:pt idx="5">
                    <c:v>1.9908629972056073</c:v>
                  </c:pt>
                  <c:pt idx="6">
                    <c:v>2.1775255123653467</c:v>
                  </c:pt>
                  <c:pt idx="7">
                    <c:v>0</c:v>
                  </c:pt>
                  <c:pt idx="8">
                    <c:v>1.7679372695539084</c:v>
                  </c:pt>
                  <c:pt idx="9">
                    <c:v>4.3490839565291894</c:v>
                  </c:pt>
                  <c:pt idx="10">
                    <c:v>4.12393049421161</c:v>
                  </c:pt>
                  <c:pt idx="11">
                    <c:v>5.2486388108147732</c:v>
                  </c:pt>
                  <c:pt idx="12">
                    <c:v>3.3333333333333357</c:v>
                  </c:pt>
                  <c:pt idx="13">
                    <c:v>2.1317548400847728</c:v>
                  </c:pt>
                  <c:pt idx="14">
                    <c:v>2.51021856169403</c:v>
                  </c:pt>
                </c:numCache>
              </c:numRef>
            </c:plus>
            <c:minus>
              <c:numRef>
                <c:f>Graph!$K$23:$K$36</c:f>
                <c:numCache>
                  <c:formatCode>General</c:formatCode>
                  <c:ptCount val="14"/>
                  <c:pt idx="0">
                    <c:v>6.1493751564540853</c:v>
                  </c:pt>
                  <c:pt idx="1">
                    <c:v>4.5471720798235884</c:v>
                  </c:pt>
                  <c:pt idx="2">
                    <c:v>3.2075014954979215</c:v>
                  </c:pt>
                  <c:pt idx="3">
                    <c:v>7.7697241195291253</c:v>
                  </c:pt>
                  <c:pt idx="4">
                    <c:v>3.8345408726083199</c:v>
                  </c:pt>
                  <c:pt idx="5">
                    <c:v>1.9908629972056073</c:v>
                  </c:pt>
                  <c:pt idx="6">
                    <c:v>2.1775255123653467</c:v>
                  </c:pt>
                  <c:pt idx="7">
                    <c:v>0</c:v>
                  </c:pt>
                  <c:pt idx="8">
                    <c:v>1.7679372695539084</c:v>
                  </c:pt>
                  <c:pt idx="9">
                    <c:v>4.3490839565291894</c:v>
                  </c:pt>
                  <c:pt idx="10">
                    <c:v>4.12393049421161</c:v>
                  </c:pt>
                  <c:pt idx="11">
                    <c:v>5.2486388108147732</c:v>
                  </c:pt>
                  <c:pt idx="12">
                    <c:v>3.3333333333333357</c:v>
                  </c:pt>
                  <c:pt idx="13">
                    <c:v>2.1317548400847728</c:v>
                  </c:pt>
                </c:numCache>
              </c:numRef>
            </c:minus>
          </c:errBars>
          <c:cat>
            <c:strRef>
              <c:f>Graph!$C$23:$C$37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F$23:$F$37</c:f>
              <c:numCache>
                <c:formatCode>0.0</c:formatCode>
                <c:ptCount val="15"/>
                <c:pt idx="0">
                  <c:v>93.222222222222229</c:v>
                </c:pt>
                <c:pt idx="1">
                  <c:v>96.969696969696955</c:v>
                </c:pt>
                <c:pt idx="2">
                  <c:v>87.329434697855746</c:v>
                </c:pt>
                <c:pt idx="3">
                  <c:v>98.826777087646647</c:v>
                </c:pt>
                <c:pt idx="4">
                  <c:v>82.444444444444443</c:v>
                </c:pt>
                <c:pt idx="5">
                  <c:v>79.310344827586206</c:v>
                </c:pt>
                <c:pt idx="6">
                  <c:v>88.307692307692307</c:v>
                </c:pt>
                <c:pt idx="7">
                  <c:v>91.999999999999986</c:v>
                </c:pt>
                <c:pt idx="8">
                  <c:v>79.13978494623656</c:v>
                </c:pt>
                <c:pt idx="9">
                  <c:v>97.222222222222229</c:v>
                </c:pt>
                <c:pt idx="10">
                  <c:v>83.156966490299808</c:v>
                </c:pt>
                <c:pt idx="11">
                  <c:v>85.15151515151517</c:v>
                </c:pt>
                <c:pt idx="12">
                  <c:v>91.1111111111111</c:v>
                </c:pt>
                <c:pt idx="13">
                  <c:v>88.307692307692307</c:v>
                </c:pt>
                <c:pt idx="14">
                  <c:v>94.2028985507246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1E7D-4267-8323-3EFC8859AE37}"/>
            </c:ext>
          </c:extLst>
        </c:ser>
        <c:ser>
          <c:idx val="1"/>
          <c:order val="2"/>
          <c:tx>
            <c:strRef>
              <c:f>Graph!$H$22</c:f>
              <c:strCache>
                <c:ptCount val="1"/>
                <c:pt idx="0">
                  <c:v>25  µg/mL</c:v>
                </c:pt>
              </c:strCache>
            </c:strRef>
          </c:tx>
          <c:spPr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I$23:$I$37</c:f>
                <c:numCache>
                  <c:formatCode>General</c:formatCode>
                  <c:ptCount val="15"/>
                  <c:pt idx="0">
                    <c:v>7.0769579151873785</c:v>
                  </c:pt>
                  <c:pt idx="1">
                    <c:v>7.4412297926113267</c:v>
                  </c:pt>
                  <c:pt idx="2">
                    <c:v>6.3322829905578111</c:v>
                  </c:pt>
                  <c:pt idx="3">
                    <c:v>4.5564336342978748</c:v>
                  </c:pt>
                  <c:pt idx="4">
                    <c:v>4.0184758488944796</c:v>
                  </c:pt>
                  <c:pt idx="5">
                    <c:v>1.9908629972056076</c:v>
                  </c:pt>
                  <c:pt idx="6">
                    <c:v>5.791240069144215</c:v>
                  </c:pt>
                  <c:pt idx="7">
                    <c:v>2.3094010767585114</c:v>
                  </c:pt>
                  <c:pt idx="8">
                    <c:v>1.4899361785538716</c:v>
                  </c:pt>
                  <c:pt idx="9">
                    <c:v>2.6210790355326967</c:v>
                  </c:pt>
                  <c:pt idx="10">
                    <c:v>1.9855961638796598</c:v>
                  </c:pt>
                  <c:pt idx="11">
                    <c:v>5.2486388108147732</c:v>
                  </c:pt>
                  <c:pt idx="12">
                    <c:v>1.9245008972987498</c:v>
                  </c:pt>
                  <c:pt idx="13">
                    <c:v>3.769492403269143</c:v>
                  </c:pt>
                  <c:pt idx="14">
                    <c:v>8.6956521739130466</c:v>
                  </c:pt>
                </c:numCache>
              </c:numRef>
            </c:plus>
            <c:minus>
              <c:numRef>
                <c:f>Graph!$I$23:$I$37</c:f>
                <c:numCache>
                  <c:formatCode>General</c:formatCode>
                  <c:ptCount val="15"/>
                  <c:pt idx="0">
                    <c:v>7.0769579151873785</c:v>
                  </c:pt>
                  <c:pt idx="1">
                    <c:v>7.4412297926113267</c:v>
                  </c:pt>
                  <c:pt idx="2">
                    <c:v>6.3322829905578111</c:v>
                  </c:pt>
                  <c:pt idx="3">
                    <c:v>4.5564336342978748</c:v>
                  </c:pt>
                  <c:pt idx="4">
                    <c:v>4.0184758488944796</c:v>
                  </c:pt>
                  <c:pt idx="5">
                    <c:v>1.9908629972056076</c:v>
                  </c:pt>
                  <c:pt idx="6">
                    <c:v>5.791240069144215</c:v>
                  </c:pt>
                  <c:pt idx="7">
                    <c:v>2.3094010767585114</c:v>
                  </c:pt>
                  <c:pt idx="8">
                    <c:v>1.4899361785538716</c:v>
                  </c:pt>
                  <c:pt idx="9">
                    <c:v>2.6210790355326967</c:v>
                  </c:pt>
                  <c:pt idx="10">
                    <c:v>1.9855961638796598</c:v>
                  </c:pt>
                  <c:pt idx="11">
                    <c:v>5.2486388108147732</c:v>
                  </c:pt>
                  <c:pt idx="12">
                    <c:v>1.9245008972987498</c:v>
                  </c:pt>
                  <c:pt idx="13">
                    <c:v>3.769492403269143</c:v>
                  </c:pt>
                  <c:pt idx="14">
                    <c:v>8.6956521739130466</c:v>
                  </c:pt>
                </c:numCache>
              </c:numRef>
            </c:minus>
          </c:errBars>
          <c:cat>
            <c:strRef>
              <c:f>Graph!$C$23:$C$37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H$23:$H$37</c:f>
              <c:numCache>
                <c:formatCode>0.0</c:formatCode>
                <c:ptCount val="15"/>
                <c:pt idx="0">
                  <c:v>91.833333333333329</c:v>
                </c:pt>
                <c:pt idx="1">
                  <c:v>101.81818181818181</c:v>
                </c:pt>
                <c:pt idx="2">
                  <c:v>98.245614035087726</c:v>
                </c:pt>
                <c:pt idx="3">
                  <c:v>100.13802622498275</c:v>
                </c:pt>
                <c:pt idx="4">
                  <c:v>83.777777777777786</c:v>
                </c:pt>
                <c:pt idx="5">
                  <c:v>74.71264367816093</c:v>
                </c:pt>
                <c:pt idx="6">
                  <c:v>89.692307692307693</c:v>
                </c:pt>
                <c:pt idx="7">
                  <c:v>94.666666666666671</c:v>
                </c:pt>
                <c:pt idx="8">
                  <c:v>79.13978494623656</c:v>
                </c:pt>
                <c:pt idx="9">
                  <c:v>110.02415458937197</c:v>
                </c:pt>
                <c:pt idx="10">
                  <c:v>94.003527336860657</c:v>
                </c:pt>
                <c:pt idx="11">
                  <c:v>96.969696969696983</c:v>
                </c:pt>
                <c:pt idx="12">
                  <c:v>97.777777777777786</c:v>
                </c:pt>
                <c:pt idx="13">
                  <c:v>92.256410256410263</c:v>
                </c:pt>
                <c:pt idx="14">
                  <c:v>95.6521739130434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1E7D-4267-8323-3EFC8859AE37}"/>
            </c:ext>
          </c:extLst>
        </c:ser>
        <c:ser>
          <c:idx val="5"/>
          <c:order val="3"/>
          <c:tx>
            <c:strRef>
              <c:f>Graph!$J$22</c:f>
              <c:strCache>
                <c:ptCount val="1"/>
                <c:pt idx="0">
                  <c:v>10 µg/m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K$23:$K$37</c:f>
                <c:numCache>
                  <c:formatCode>General</c:formatCode>
                  <c:ptCount val="15"/>
                  <c:pt idx="0">
                    <c:v>6.1493751564540853</c:v>
                  </c:pt>
                  <c:pt idx="1">
                    <c:v>4.5471720798235884</c:v>
                  </c:pt>
                  <c:pt idx="2">
                    <c:v>3.2075014954979215</c:v>
                  </c:pt>
                  <c:pt idx="3">
                    <c:v>7.7697241195291253</c:v>
                  </c:pt>
                  <c:pt idx="4">
                    <c:v>3.8345408726083199</c:v>
                  </c:pt>
                  <c:pt idx="5">
                    <c:v>1.9908629972056073</c:v>
                  </c:pt>
                  <c:pt idx="6">
                    <c:v>2.1775255123653467</c:v>
                  </c:pt>
                  <c:pt idx="7">
                    <c:v>0</c:v>
                  </c:pt>
                  <c:pt idx="8">
                    <c:v>1.7679372695539084</c:v>
                  </c:pt>
                  <c:pt idx="9">
                    <c:v>4.3490839565291894</c:v>
                  </c:pt>
                  <c:pt idx="10">
                    <c:v>4.12393049421161</c:v>
                  </c:pt>
                  <c:pt idx="11">
                    <c:v>5.2486388108147732</c:v>
                  </c:pt>
                  <c:pt idx="12">
                    <c:v>3.3333333333333357</c:v>
                  </c:pt>
                  <c:pt idx="13">
                    <c:v>2.1317548400847728</c:v>
                  </c:pt>
                  <c:pt idx="14">
                    <c:v>2.51021856169403</c:v>
                  </c:pt>
                </c:numCache>
              </c:numRef>
            </c:plus>
            <c:minus>
              <c:numRef>
                <c:f>Graph!$K$23:$K$37</c:f>
                <c:numCache>
                  <c:formatCode>General</c:formatCode>
                  <c:ptCount val="15"/>
                  <c:pt idx="0">
                    <c:v>6.1493751564540853</c:v>
                  </c:pt>
                  <c:pt idx="1">
                    <c:v>4.5471720798235884</c:v>
                  </c:pt>
                  <c:pt idx="2">
                    <c:v>3.2075014954979215</c:v>
                  </c:pt>
                  <c:pt idx="3">
                    <c:v>7.7697241195291253</c:v>
                  </c:pt>
                  <c:pt idx="4">
                    <c:v>3.8345408726083199</c:v>
                  </c:pt>
                  <c:pt idx="5">
                    <c:v>1.9908629972056073</c:v>
                  </c:pt>
                  <c:pt idx="6">
                    <c:v>2.1775255123653467</c:v>
                  </c:pt>
                  <c:pt idx="7">
                    <c:v>0</c:v>
                  </c:pt>
                  <c:pt idx="8">
                    <c:v>1.7679372695539084</c:v>
                  </c:pt>
                  <c:pt idx="9">
                    <c:v>4.3490839565291894</c:v>
                  </c:pt>
                  <c:pt idx="10">
                    <c:v>4.12393049421161</c:v>
                  </c:pt>
                  <c:pt idx="11">
                    <c:v>5.2486388108147732</c:v>
                  </c:pt>
                  <c:pt idx="12">
                    <c:v>3.3333333333333357</c:v>
                  </c:pt>
                  <c:pt idx="13">
                    <c:v>2.1317548400847728</c:v>
                  </c:pt>
                  <c:pt idx="14">
                    <c:v>2.51021856169403</c:v>
                  </c:pt>
                </c:numCache>
              </c:numRef>
            </c:minus>
          </c:errBars>
          <c:cat>
            <c:strRef>
              <c:f>Graph!$C$23:$C$37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J$23:$J$37</c:f>
              <c:numCache>
                <c:formatCode>0.0</c:formatCode>
                <c:ptCount val="15"/>
                <c:pt idx="0">
                  <c:v>93.222222222222229</c:v>
                </c:pt>
                <c:pt idx="1">
                  <c:v>95.382395382395387</c:v>
                </c:pt>
                <c:pt idx="2">
                  <c:v>98.148148148148152</c:v>
                </c:pt>
                <c:pt idx="3">
                  <c:v>95.790200138026236</c:v>
                </c:pt>
                <c:pt idx="4">
                  <c:v>87.8888888888889</c:v>
                </c:pt>
                <c:pt idx="5">
                  <c:v>87.356321839080465</c:v>
                </c:pt>
                <c:pt idx="6">
                  <c:v>94.820512820512818</c:v>
                </c:pt>
                <c:pt idx="7">
                  <c:v>96</c:v>
                </c:pt>
                <c:pt idx="8">
                  <c:v>81.326164874551964</c:v>
                </c:pt>
                <c:pt idx="9">
                  <c:v>104.28743961352659</c:v>
                </c:pt>
                <c:pt idx="10">
                  <c:v>95.238095238095241</c:v>
                </c:pt>
                <c:pt idx="11">
                  <c:v>96.969696969696983</c:v>
                </c:pt>
                <c:pt idx="12">
                  <c:v>96.666666666666671</c:v>
                </c:pt>
                <c:pt idx="13">
                  <c:v>93.538461538461547</c:v>
                </c:pt>
                <c:pt idx="14">
                  <c:v>92.75362318840581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1E7D-4267-8323-3EFC8859AE37}"/>
            </c:ext>
          </c:extLst>
        </c:ser>
        <c:ser>
          <c:idx val="9"/>
          <c:order val="4"/>
          <c:tx>
            <c:strRef>
              <c:f>Graph!$L$22</c:f>
              <c:strCache>
                <c:ptCount val="1"/>
                <c:pt idx="0">
                  <c:v>5 µg/mL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M$23:$M$37</c:f>
                <c:numCache>
                  <c:formatCode>General</c:formatCode>
                  <c:ptCount val="15"/>
                  <c:pt idx="0">
                    <c:v>6.5280586267075851</c:v>
                  </c:pt>
                  <c:pt idx="1">
                    <c:v>4.6540991119394404</c:v>
                  </c:pt>
                  <c:pt idx="2">
                    <c:v>0.16881586818410591</c:v>
                  </c:pt>
                  <c:pt idx="3">
                    <c:v>2.5102185616940136</c:v>
                  </c:pt>
                  <c:pt idx="4">
                    <c:v>7.0244282751404583</c:v>
                  </c:pt>
                  <c:pt idx="5">
                    <c:v>0</c:v>
                  </c:pt>
                  <c:pt idx="6">
                    <c:v>3.8461538461538467</c:v>
                  </c:pt>
                  <c:pt idx="7">
                    <c:v>2.3094010767585034</c:v>
                  </c:pt>
                  <c:pt idx="8">
                    <c:v>1.6140975267666964</c:v>
                  </c:pt>
                  <c:pt idx="9">
                    <c:v>2.6148110017646085</c:v>
                  </c:pt>
                  <c:pt idx="10">
                    <c:v>9.4992825463811084</c:v>
                  </c:pt>
                  <c:pt idx="11">
                    <c:v>7.1731397081135233</c:v>
                  </c:pt>
                  <c:pt idx="12">
                    <c:v>3.3333333333333286</c:v>
                  </c:pt>
                  <c:pt idx="13">
                    <c:v>2.1775255123653467</c:v>
                  </c:pt>
                  <c:pt idx="14">
                    <c:v>6.6414140506606349</c:v>
                  </c:pt>
                </c:numCache>
              </c:numRef>
            </c:plus>
            <c:minus>
              <c:numRef>
                <c:f>Graph!$M$23:$M$37</c:f>
                <c:numCache>
                  <c:formatCode>General</c:formatCode>
                  <c:ptCount val="15"/>
                  <c:pt idx="0">
                    <c:v>6.5280586267075851</c:v>
                  </c:pt>
                  <c:pt idx="1">
                    <c:v>4.6540991119394404</c:v>
                  </c:pt>
                  <c:pt idx="2">
                    <c:v>0.16881586818410591</c:v>
                  </c:pt>
                  <c:pt idx="3">
                    <c:v>2.5102185616940136</c:v>
                  </c:pt>
                  <c:pt idx="4">
                    <c:v>7.0244282751404583</c:v>
                  </c:pt>
                  <c:pt idx="5">
                    <c:v>0</c:v>
                  </c:pt>
                  <c:pt idx="6">
                    <c:v>3.8461538461538467</c:v>
                  </c:pt>
                  <c:pt idx="7">
                    <c:v>2.3094010767585034</c:v>
                  </c:pt>
                  <c:pt idx="8">
                    <c:v>1.6140975267666964</c:v>
                  </c:pt>
                  <c:pt idx="9">
                    <c:v>2.6148110017646085</c:v>
                  </c:pt>
                  <c:pt idx="10">
                    <c:v>9.4992825463811084</c:v>
                  </c:pt>
                  <c:pt idx="11">
                    <c:v>7.1731397081135233</c:v>
                  </c:pt>
                  <c:pt idx="12">
                    <c:v>3.3333333333333286</c:v>
                  </c:pt>
                  <c:pt idx="13">
                    <c:v>2.1775255123653467</c:v>
                  </c:pt>
                  <c:pt idx="14">
                    <c:v>6.6414140506606349</c:v>
                  </c:pt>
                </c:numCache>
              </c:numRef>
            </c:minus>
          </c:errBars>
          <c:cat>
            <c:strRef>
              <c:f>Graph!$C$23:$C$37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L$23:$L$37</c:f>
              <c:numCache>
                <c:formatCode>0.0</c:formatCode>
                <c:ptCount val="15"/>
                <c:pt idx="0">
                  <c:v>87.52525252525254</c:v>
                </c:pt>
                <c:pt idx="1">
                  <c:v>100.07215007215007</c:v>
                </c:pt>
                <c:pt idx="2">
                  <c:v>94.541910331384017</c:v>
                </c:pt>
                <c:pt idx="3">
                  <c:v>98.550724637681171</c:v>
                </c:pt>
                <c:pt idx="4">
                  <c:v>96.055555555555543</c:v>
                </c:pt>
                <c:pt idx="5">
                  <c:v>86.206896551724142</c:v>
                </c:pt>
                <c:pt idx="6">
                  <c:v>96.153846153846146</c:v>
                </c:pt>
                <c:pt idx="7">
                  <c:v>98.666666666666671</c:v>
                </c:pt>
                <c:pt idx="8">
                  <c:v>85.734767025089624</c:v>
                </c:pt>
                <c:pt idx="9">
                  <c:v>107.18599033816425</c:v>
                </c:pt>
                <c:pt idx="10">
                  <c:v>96.472663139329811</c:v>
                </c:pt>
                <c:pt idx="11">
                  <c:v>99.191919191919183</c:v>
                </c:pt>
                <c:pt idx="12">
                  <c:v>100</c:v>
                </c:pt>
                <c:pt idx="13">
                  <c:v>94.820512820512818</c:v>
                </c:pt>
                <c:pt idx="14">
                  <c:v>97.10144927536232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1E7D-4267-8323-3EFC8859AE37}"/>
            </c:ext>
          </c:extLst>
        </c:ser>
        <c:ser>
          <c:idx val="0"/>
          <c:order val="5"/>
          <c:tx>
            <c:strRef>
              <c:f>Graph!$N$22</c:f>
              <c:strCache>
                <c:ptCount val="1"/>
                <c:pt idx="0">
                  <c:v>0 µg/mL</c:v>
                </c:pt>
              </c:strCache>
            </c:strRef>
          </c:tx>
          <c:invertIfNegative val="0"/>
          <c:errBars>
            <c:errBarType val="both"/>
            <c:errValType val="fixedVal"/>
            <c:noEndCap val="0"/>
            <c:val val="0"/>
          </c:errBars>
          <c:val>
            <c:numRef>
              <c:f>Graph!$N$23:$N$37</c:f>
              <c:numCache>
                <c:formatCode>General</c:formatCode>
                <c:ptCount val="15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97B7-4ABB-8D4D-479BBD89DE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51469296"/>
        <c:axId val="349914600"/>
      </c:barChart>
      <c:catAx>
        <c:axId val="3514692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5400000" vert="horz"/>
          <a:lstStyle/>
          <a:p>
            <a:pPr>
              <a:defRPr sz="800">
                <a:latin typeface="+mn-lt"/>
                <a:cs typeface="Times New Roman" panose="02020603050405020304" pitchFamily="18" charset="0"/>
              </a:defRPr>
            </a:pPr>
            <a:endParaRPr lang="it-IT"/>
          </a:p>
        </c:txPr>
        <c:crossAx val="349914600"/>
        <c:crosses val="autoZero"/>
        <c:auto val="1"/>
        <c:lblAlgn val="ctr"/>
        <c:lblOffset val="100"/>
        <c:noMultiLvlLbl val="0"/>
      </c:catAx>
      <c:valAx>
        <c:axId val="34991460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>
                    <a:latin typeface="+mn-lt"/>
                  </a:defRPr>
                </a:pPr>
                <a:r>
                  <a:rPr lang="en-GB" sz="800" b="0">
                    <a:latin typeface="+mn-lt"/>
                    <a:cs typeface="Times New Roman" panose="02020603050405020304" pitchFamily="18" charset="0"/>
                  </a:rPr>
                  <a:t>Colony</a:t>
                </a:r>
                <a:r>
                  <a:rPr lang="en-GB" sz="800" b="0" baseline="0">
                    <a:latin typeface="+mn-lt"/>
                    <a:cs typeface="Times New Roman" panose="02020603050405020304" pitchFamily="18" charset="0"/>
                  </a:rPr>
                  <a:t> diameter  (% relative to control) </a:t>
                </a:r>
                <a:r>
                  <a:rPr lang="en-GB" sz="800" b="0">
                    <a:latin typeface="+mn-lt"/>
                    <a:cs typeface="Times New Roman" panose="02020603050405020304" pitchFamily="18" charset="0"/>
                  </a:rPr>
                  <a:t> </a:t>
                </a:r>
              </a:p>
            </c:rich>
          </c:tx>
          <c:layout>
            <c:manualLayout>
              <c:xMode val="edge"/>
              <c:yMode val="edge"/>
              <c:x val="2.0298128766254361E-2"/>
              <c:y val="0.32612817595752747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351469296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800">
              <a:latin typeface="+mn-lt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spPr>
    <a:ln>
      <a:solidFill>
        <a:schemeClr val="bg1"/>
      </a:solidFill>
    </a:ln>
  </c:sp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9229</cdr:x>
      <cdr:y>0.14221</cdr:y>
    </cdr:from>
    <cdr:to>
      <cdr:x>0.11132</cdr:x>
      <cdr:y>0.17406</cdr:y>
    </cdr:to>
    <cdr:sp macro="" textlink="">
      <cdr:nvSpPr>
        <cdr:cNvPr id="2" name="CasellaDiTesto 1"/>
        <cdr:cNvSpPr txBox="1"/>
      </cdr:nvSpPr>
      <cdr:spPr>
        <a:xfrm xmlns:a="http://schemas.openxmlformats.org/drawingml/2006/main">
          <a:off x="923927" y="1190621"/>
          <a:ext cx="190505" cy="2666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06771</cdr:x>
      <cdr:y>0.21209</cdr:y>
    </cdr:from>
    <cdr:to>
      <cdr:x>0.08658</cdr:x>
      <cdr:y>0.24423</cdr:y>
    </cdr:to>
    <cdr:sp macro="" textlink="">
      <cdr:nvSpPr>
        <cdr:cNvPr id="3" name="CasellaDiTesto 2"/>
        <cdr:cNvSpPr txBox="1"/>
      </cdr:nvSpPr>
      <cdr:spPr>
        <a:xfrm xmlns:a="http://schemas.openxmlformats.org/drawingml/2006/main">
          <a:off x="619127" y="1488868"/>
          <a:ext cx="172562" cy="2256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07421</cdr:x>
      <cdr:y>0.137</cdr:y>
    </cdr:from>
    <cdr:to>
      <cdr:x>0.11227</cdr:x>
      <cdr:y>0.17909</cdr:y>
    </cdr:to>
    <cdr:sp macro="" textlink="">
      <cdr:nvSpPr>
        <cdr:cNvPr id="4" name="CasellaDiTesto 3"/>
        <cdr:cNvSpPr txBox="1"/>
      </cdr:nvSpPr>
      <cdr:spPr>
        <a:xfrm xmlns:a="http://schemas.openxmlformats.org/drawingml/2006/main">
          <a:off x="678576" y="961736"/>
          <a:ext cx="348021" cy="29547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 a  </a:t>
          </a:r>
        </a:p>
      </cdr:txBody>
    </cdr:sp>
  </cdr:relSizeAnchor>
  <cdr:relSizeAnchor xmlns:cdr="http://schemas.openxmlformats.org/drawingml/2006/chartDrawing">
    <cdr:from>
      <cdr:x>0.09895</cdr:x>
      <cdr:y>0.17748</cdr:y>
    </cdr:from>
    <cdr:to>
      <cdr:x>0.11513</cdr:x>
      <cdr:y>0.21047</cdr:y>
    </cdr:to>
    <cdr:sp macro="" textlink="">
      <cdr:nvSpPr>
        <cdr:cNvPr id="5" name="CasellaDiTesto 4"/>
        <cdr:cNvSpPr txBox="1"/>
      </cdr:nvSpPr>
      <cdr:spPr>
        <a:xfrm xmlns:a="http://schemas.openxmlformats.org/drawingml/2006/main">
          <a:off x="990591" y="1485932"/>
          <a:ext cx="161974" cy="2762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2464</cdr:x>
      <cdr:y>0.33788</cdr:y>
    </cdr:from>
    <cdr:to>
      <cdr:x>0.14081</cdr:x>
      <cdr:y>0.36405</cdr:y>
    </cdr:to>
    <cdr:sp macro="" textlink="">
      <cdr:nvSpPr>
        <cdr:cNvPr id="7" name="CasellaDiTesto 6"/>
        <cdr:cNvSpPr txBox="1"/>
      </cdr:nvSpPr>
      <cdr:spPr>
        <a:xfrm xmlns:a="http://schemas.openxmlformats.org/drawingml/2006/main">
          <a:off x="1247782" y="2828872"/>
          <a:ext cx="161874" cy="2191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900"/>
            <a:t>b</a:t>
          </a:r>
        </a:p>
      </cdr:txBody>
    </cdr:sp>
  </cdr:relSizeAnchor>
  <cdr:relSizeAnchor xmlns:cdr="http://schemas.openxmlformats.org/drawingml/2006/chartDrawing">
    <cdr:from>
      <cdr:x>0.10371</cdr:x>
      <cdr:y>0.13425</cdr:y>
    </cdr:from>
    <cdr:to>
      <cdr:x>0.13036</cdr:x>
      <cdr:y>0.16724</cdr:y>
    </cdr:to>
    <cdr:sp macro="" textlink="">
      <cdr:nvSpPr>
        <cdr:cNvPr id="8" name="CasellaDiTesto 7"/>
        <cdr:cNvSpPr txBox="1"/>
      </cdr:nvSpPr>
      <cdr:spPr>
        <a:xfrm xmlns:a="http://schemas.openxmlformats.org/drawingml/2006/main">
          <a:off x="1038185" y="1123981"/>
          <a:ext cx="266787" cy="2762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3892</cdr:x>
      <cdr:y>0.06826</cdr:y>
    </cdr:from>
    <cdr:to>
      <cdr:x>0.17031</cdr:x>
      <cdr:y>0.09898</cdr:y>
    </cdr:to>
    <cdr:sp macro="" textlink="">
      <cdr:nvSpPr>
        <cdr:cNvPr id="9" name="CasellaDiTesto 8"/>
        <cdr:cNvSpPr txBox="1"/>
      </cdr:nvSpPr>
      <cdr:spPr>
        <a:xfrm xmlns:a="http://schemas.openxmlformats.org/drawingml/2006/main">
          <a:off x="1390656" y="571474"/>
          <a:ext cx="314238" cy="25720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3225</cdr:x>
      <cdr:y>0.11718</cdr:y>
    </cdr:from>
    <cdr:to>
      <cdr:x>0.15699</cdr:x>
      <cdr:y>0.14789</cdr:y>
    </cdr:to>
    <cdr:sp macro="" textlink="">
      <cdr:nvSpPr>
        <cdr:cNvPr id="10" name="CasellaDiTesto 9"/>
        <cdr:cNvSpPr txBox="1"/>
      </cdr:nvSpPr>
      <cdr:spPr>
        <a:xfrm xmlns:a="http://schemas.openxmlformats.org/drawingml/2006/main">
          <a:off x="1323899" y="981076"/>
          <a:ext cx="247666" cy="2571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5319</cdr:x>
      <cdr:y>0.09898</cdr:y>
    </cdr:from>
    <cdr:to>
      <cdr:x>0.18363</cdr:x>
      <cdr:y>0.13083</cdr:y>
    </cdr:to>
    <cdr:sp macro="" textlink="">
      <cdr:nvSpPr>
        <cdr:cNvPr id="11" name="CasellaDiTesto 10"/>
        <cdr:cNvSpPr txBox="1"/>
      </cdr:nvSpPr>
      <cdr:spPr>
        <a:xfrm xmlns:a="http://schemas.openxmlformats.org/drawingml/2006/main">
          <a:off x="1533552" y="828705"/>
          <a:ext cx="304728" cy="2666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4937</cdr:x>
      <cdr:y>0.12856</cdr:y>
    </cdr:from>
    <cdr:to>
      <cdr:x>0.17126</cdr:x>
      <cdr:y>0.15814</cdr:y>
    </cdr:to>
    <cdr:sp macro="" textlink="">
      <cdr:nvSpPr>
        <cdr:cNvPr id="12" name="CasellaDiTesto 11"/>
        <cdr:cNvSpPr txBox="1"/>
      </cdr:nvSpPr>
      <cdr:spPr>
        <a:xfrm xmlns:a="http://schemas.openxmlformats.org/drawingml/2006/main">
          <a:off x="1495342" y="1076365"/>
          <a:ext cx="219136" cy="24765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7888</cdr:x>
      <cdr:y>0.31286</cdr:y>
    </cdr:from>
    <cdr:to>
      <cdr:x>0.19981</cdr:x>
      <cdr:y>0.33675</cdr:y>
    </cdr:to>
    <cdr:sp macro="" textlink="">
      <cdr:nvSpPr>
        <cdr:cNvPr id="13" name="CasellaDiTesto 12"/>
        <cdr:cNvSpPr txBox="1"/>
      </cdr:nvSpPr>
      <cdr:spPr>
        <a:xfrm xmlns:a="http://schemas.openxmlformats.org/drawingml/2006/main">
          <a:off x="1790737" y="2619393"/>
          <a:ext cx="209526" cy="20001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18268</cdr:x>
      <cdr:y>0.19341</cdr:y>
    </cdr:from>
    <cdr:to>
      <cdr:x>0.20362</cdr:x>
      <cdr:y>0.22185</cdr:y>
    </cdr:to>
    <cdr:sp macro="" textlink="">
      <cdr:nvSpPr>
        <cdr:cNvPr id="14" name="CasellaDiTesto 13"/>
        <cdr:cNvSpPr txBox="1"/>
      </cdr:nvSpPr>
      <cdr:spPr>
        <a:xfrm xmlns:a="http://schemas.openxmlformats.org/drawingml/2006/main">
          <a:off x="1828790" y="1619315"/>
          <a:ext cx="209625" cy="2381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16205</cdr:x>
      <cdr:y>0.11888</cdr:y>
    </cdr:from>
    <cdr:to>
      <cdr:x>0.1906</cdr:x>
      <cdr:y>0.16325</cdr:y>
    </cdr:to>
    <cdr:sp macro="" textlink="">
      <cdr:nvSpPr>
        <cdr:cNvPr id="15" name="CasellaDiTesto 14"/>
        <cdr:cNvSpPr txBox="1"/>
      </cdr:nvSpPr>
      <cdr:spPr>
        <a:xfrm xmlns:a="http://schemas.openxmlformats.org/drawingml/2006/main" rot="16200000">
          <a:off x="1456547" y="859746"/>
          <a:ext cx="311477" cy="26106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20077</cdr:x>
      <cdr:y>0.12172</cdr:y>
    </cdr:from>
    <cdr:to>
      <cdr:x>0.23312</cdr:x>
      <cdr:y>0.1604</cdr:y>
    </cdr:to>
    <cdr:sp macro="" textlink="">
      <cdr:nvSpPr>
        <cdr:cNvPr id="16" name="CasellaDiTesto 15"/>
        <cdr:cNvSpPr txBox="1"/>
      </cdr:nvSpPr>
      <cdr:spPr>
        <a:xfrm xmlns:a="http://schemas.openxmlformats.org/drawingml/2006/main" rot="16200000">
          <a:off x="2009830" y="1019104"/>
          <a:ext cx="323848" cy="32384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19505</cdr:x>
      <cdr:y>0.09215</cdr:y>
    </cdr:from>
    <cdr:to>
      <cdr:x>0.22169</cdr:x>
      <cdr:y>0.13538</cdr:y>
    </cdr:to>
    <cdr:sp macro="" textlink="">
      <cdr:nvSpPr>
        <cdr:cNvPr id="17" name="CasellaDiTesto 16"/>
        <cdr:cNvSpPr txBox="1"/>
      </cdr:nvSpPr>
      <cdr:spPr>
        <a:xfrm xmlns:a="http://schemas.openxmlformats.org/drawingml/2006/main" rot="16200000">
          <a:off x="1904983" y="819130"/>
          <a:ext cx="361942" cy="26668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24262</cdr:x>
      <cdr:y>0.08304</cdr:y>
    </cdr:from>
    <cdr:to>
      <cdr:x>0.26927</cdr:x>
      <cdr:y>0.11717</cdr:y>
    </cdr:to>
    <cdr:sp macro="" textlink="">
      <cdr:nvSpPr>
        <cdr:cNvPr id="18" name="CasellaDiTesto 17"/>
        <cdr:cNvSpPr txBox="1"/>
      </cdr:nvSpPr>
      <cdr:spPr>
        <a:xfrm xmlns:a="http://schemas.openxmlformats.org/drawingml/2006/main">
          <a:off x="2428794" y="695250"/>
          <a:ext cx="266788" cy="28575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1313</cdr:x>
      <cdr:y>0.16723</cdr:y>
    </cdr:from>
    <cdr:to>
      <cdr:x>0.23026</cdr:x>
      <cdr:y>0.19454</cdr:y>
    </cdr:to>
    <cdr:sp macro="" textlink="">
      <cdr:nvSpPr>
        <cdr:cNvPr id="19" name="CasellaDiTesto 18"/>
        <cdr:cNvSpPr txBox="1"/>
      </cdr:nvSpPr>
      <cdr:spPr>
        <a:xfrm xmlns:a="http://schemas.openxmlformats.org/drawingml/2006/main">
          <a:off x="2133593" y="1400119"/>
          <a:ext cx="171485" cy="2286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5309</cdr:x>
      <cdr:y>0.09784</cdr:y>
    </cdr:from>
    <cdr:to>
      <cdr:x>0.27022</cdr:x>
      <cdr:y>0.12287</cdr:y>
    </cdr:to>
    <cdr:sp macro="" textlink="">
      <cdr:nvSpPr>
        <cdr:cNvPr id="20" name="CasellaDiTesto 19"/>
        <cdr:cNvSpPr txBox="1"/>
      </cdr:nvSpPr>
      <cdr:spPr>
        <a:xfrm xmlns:a="http://schemas.openxmlformats.org/drawingml/2006/main">
          <a:off x="2533622" y="819163"/>
          <a:ext cx="171485" cy="2095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748</cdr:x>
      <cdr:y>0.13284</cdr:y>
    </cdr:from>
    <cdr:to>
      <cdr:x>0.29193</cdr:x>
      <cdr:y>0.16129</cdr:y>
    </cdr:to>
    <cdr:sp macro="" textlink="">
      <cdr:nvSpPr>
        <cdr:cNvPr id="21" name="CasellaDiTesto 20"/>
        <cdr:cNvSpPr txBox="1"/>
      </cdr:nvSpPr>
      <cdr:spPr>
        <a:xfrm xmlns:a="http://schemas.openxmlformats.org/drawingml/2006/main">
          <a:off x="2512741" y="932518"/>
          <a:ext cx="156636" cy="199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5786</cdr:x>
      <cdr:y>0.11036</cdr:y>
    </cdr:from>
    <cdr:to>
      <cdr:x>0.29972</cdr:x>
      <cdr:y>0.14108</cdr:y>
    </cdr:to>
    <cdr:sp macro="" textlink="">
      <cdr:nvSpPr>
        <cdr:cNvPr id="22" name="CasellaDiTesto 21"/>
        <cdr:cNvSpPr txBox="1"/>
      </cdr:nvSpPr>
      <cdr:spPr>
        <a:xfrm xmlns:a="http://schemas.openxmlformats.org/drawingml/2006/main">
          <a:off x="2581329" y="923947"/>
          <a:ext cx="419051" cy="25720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 a</a:t>
          </a:r>
        </a:p>
      </cdr:txBody>
    </cdr:sp>
  </cdr:relSizeAnchor>
  <cdr:relSizeAnchor xmlns:cdr="http://schemas.openxmlformats.org/drawingml/2006/chartDrawing">
    <cdr:from>
      <cdr:x>0.29115</cdr:x>
      <cdr:y>0.37542</cdr:y>
    </cdr:from>
    <cdr:to>
      <cdr:x>0.30638</cdr:x>
      <cdr:y>0.40045</cdr:y>
    </cdr:to>
    <cdr:sp macro="" textlink="">
      <cdr:nvSpPr>
        <cdr:cNvPr id="24" name="CasellaDiTesto 23"/>
        <cdr:cNvSpPr txBox="1"/>
      </cdr:nvSpPr>
      <cdr:spPr>
        <a:xfrm xmlns:a="http://schemas.openxmlformats.org/drawingml/2006/main">
          <a:off x="2914658" y="3143195"/>
          <a:ext cx="152464" cy="2095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29591</cdr:x>
      <cdr:y>0.2264</cdr:y>
    </cdr:from>
    <cdr:to>
      <cdr:x>0.31684</cdr:x>
      <cdr:y>0.25484</cdr:y>
    </cdr:to>
    <cdr:sp macro="" textlink="">
      <cdr:nvSpPr>
        <cdr:cNvPr id="25" name="CasellaDiTesto 24"/>
        <cdr:cNvSpPr txBox="1"/>
      </cdr:nvSpPr>
      <cdr:spPr>
        <a:xfrm xmlns:a="http://schemas.openxmlformats.org/drawingml/2006/main">
          <a:off x="2962295" y="1895489"/>
          <a:ext cx="209525" cy="2381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30352</cdr:x>
      <cdr:y>0.20023</cdr:y>
    </cdr:from>
    <cdr:to>
      <cdr:x>0.33778</cdr:x>
      <cdr:y>0.24801</cdr:y>
    </cdr:to>
    <cdr:sp macro="" textlink="">
      <cdr:nvSpPr>
        <cdr:cNvPr id="26" name="CasellaDiTesto 25"/>
        <cdr:cNvSpPr txBox="1"/>
      </cdr:nvSpPr>
      <cdr:spPr>
        <a:xfrm xmlns:a="http://schemas.openxmlformats.org/drawingml/2006/main" rot="16200000">
          <a:off x="3009958" y="1704969"/>
          <a:ext cx="400037" cy="34296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c</a:t>
          </a:r>
        </a:p>
      </cdr:txBody>
    </cdr:sp>
  </cdr:relSizeAnchor>
  <cdr:relSizeAnchor xmlns:cdr="http://schemas.openxmlformats.org/drawingml/2006/chartDrawing">
    <cdr:from>
      <cdr:x>0.31209</cdr:x>
      <cdr:y>0.14562</cdr:y>
    </cdr:from>
    <cdr:to>
      <cdr:x>0.3473</cdr:x>
      <cdr:y>0.21957</cdr:y>
    </cdr:to>
    <cdr:sp macro="" textlink="">
      <cdr:nvSpPr>
        <cdr:cNvPr id="27" name="CasellaDiTesto 26"/>
        <cdr:cNvSpPr txBox="1"/>
      </cdr:nvSpPr>
      <cdr:spPr>
        <a:xfrm xmlns:a="http://schemas.openxmlformats.org/drawingml/2006/main" rot="16200000">
          <a:off x="2990881" y="1352532"/>
          <a:ext cx="619144" cy="35248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c</a:t>
          </a:r>
        </a:p>
      </cdr:txBody>
    </cdr:sp>
  </cdr:relSizeAnchor>
  <cdr:relSizeAnchor xmlns:cdr="http://schemas.openxmlformats.org/drawingml/2006/chartDrawing">
    <cdr:from>
      <cdr:x>0.32065</cdr:x>
      <cdr:y>0.10352</cdr:y>
    </cdr:from>
    <cdr:to>
      <cdr:x>0.36251</cdr:x>
      <cdr:y>0.14903</cdr:y>
    </cdr:to>
    <cdr:sp macro="" textlink="">
      <cdr:nvSpPr>
        <cdr:cNvPr id="28" name="CasellaDiTesto 27"/>
        <cdr:cNvSpPr txBox="1"/>
      </cdr:nvSpPr>
      <cdr:spPr>
        <a:xfrm xmlns:a="http://schemas.openxmlformats.org/drawingml/2006/main" rot="16200000">
          <a:off x="3229001" y="847739"/>
          <a:ext cx="381031" cy="41905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32722</cdr:x>
      <cdr:y>0.13495</cdr:y>
    </cdr:from>
    <cdr:to>
      <cdr:x>0.34911</cdr:x>
      <cdr:y>0.17136</cdr:y>
    </cdr:to>
    <cdr:sp macro="" textlink="">
      <cdr:nvSpPr>
        <cdr:cNvPr id="29" name="CasellaDiTesto 28"/>
        <cdr:cNvSpPr txBox="1"/>
      </cdr:nvSpPr>
      <cdr:spPr>
        <a:xfrm xmlns:a="http://schemas.openxmlformats.org/drawingml/2006/main">
          <a:off x="2992084" y="947323"/>
          <a:ext cx="200163" cy="25559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4538</cdr:x>
      <cdr:y>0.40273</cdr:y>
    </cdr:from>
    <cdr:to>
      <cdr:x>0.36346</cdr:x>
      <cdr:y>0.44255</cdr:y>
    </cdr:to>
    <cdr:sp macro="" textlink="">
      <cdr:nvSpPr>
        <cdr:cNvPr id="30" name="CasellaDiTesto 29"/>
        <cdr:cNvSpPr txBox="1"/>
      </cdr:nvSpPr>
      <cdr:spPr>
        <a:xfrm xmlns:a="http://schemas.openxmlformats.org/drawingml/2006/main">
          <a:off x="3457528" y="3371847"/>
          <a:ext cx="180995" cy="33339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35074</cdr:x>
      <cdr:y>0.26482</cdr:y>
    </cdr:from>
    <cdr:to>
      <cdr:x>0.39736</cdr:x>
      <cdr:y>0.31487</cdr:y>
    </cdr:to>
    <cdr:sp macro="" textlink="">
      <cdr:nvSpPr>
        <cdr:cNvPr id="31" name="CasellaDiTesto 30"/>
        <cdr:cNvSpPr txBox="1"/>
      </cdr:nvSpPr>
      <cdr:spPr>
        <a:xfrm xmlns:a="http://schemas.openxmlformats.org/drawingml/2006/main">
          <a:off x="3207197" y="1859018"/>
          <a:ext cx="426293" cy="35135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 c </a:t>
          </a:r>
        </a:p>
      </cdr:txBody>
    </cdr:sp>
  </cdr:relSizeAnchor>
  <cdr:relSizeAnchor xmlns:cdr="http://schemas.openxmlformats.org/drawingml/2006/chartDrawing">
    <cdr:from>
      <cdr:x>0.36537</cdr:x>
      <cdr:y>0.20706</cdr:y>
    </cdr:from>
    <cdr:to>
      <cdr:x>0.40724</cdr:x>
      <cdr:y>0.24232</cdr:y>
    </cdr:to>
    <cdr:sp macro="" textlink="">
      <cdr:nvSpPr>
        <cdr:cNvPr id="32" name="CasellaDiTesto 31"/>
        <cdr:cNvSpPr txBox="1"/>
      </cdr:nvSpPr>
      <cdr:spPr>
        <a:xfrm xmlns:a="http://schemas.openxmlformats.org/drawingml/2006/main">
          <a:off x="3657599" y="1733565"/>
          <a:ext cx="419151" cy="29521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  b </a:t>
          </a:r>
        </a:p>
      </cdr:txBody>
    </cdr:sp>
  </cdr:relSizeAnchor>
  <cdr:relSizeAnchor xmlns:cdr="http://schemas.openxmlformats.org/drawingml/2006/chartDrawing">
    <cdr:from>
      <cdr:x>0.38344</cdr:x>
      <cdr:y>0.12742</cdr:y>
    </cdr:from>
    <cdr:to>
      <cdr:x>0.40913</cdr:x>
      <cdr:y>0.15586</cdr:y>
    </cdr:to>
    <cdr:sp macro="" textlink="">
      <cdr:nvSpPr>
        <cdr:cNvPr id="33" name="CasellaDiTesto 32"/>
        <cdr:cNvSpPr txBox="1"/>
      </cdr:nvSpPr>
      <cdr:spPr>
        <a:xfrm xmlns:a="http://schemas.openxmlformats.org/drawingml/2006/main">
          <a:off x="3838509" y="1066840"/>
          <a:ext cx="257176" cy="23811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0153</cdr:x>
      <cdr:y>0.26166</cdr:y>
    </cdr:from>
    <cdr:to>
      <cdr:x>0.42708</cdr:x>
      <cdr:y>0.29036</cdr:y>
    </cdr:to>
    <cdr:sp macro="" textlink="">
      <cdr:nvSpPr>
        <cdr:cNvPr id="34" name="CasellaDiTesto 33"/>
        <cdr:cNvSpPr txBox="1"/>
      </cdr:nvSpPr>
      <cdr:spPr>
        <a:xfrm xmlns:a="http://schemas.openxmlformats.org/drawingml/2006/main">
          <a:off x="3671589" y="1836852"/>
          <a:ext cx="233661" cy="20149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40914</cdr:x>
      <cdr:y>0.16951</cdr:y>
    </cdr:from>
    <cdr:to>
      <cdr:x>0.451</cdr:x>
      <cdr:y>0.22639</cdr:y>
    </cdr:to>
    <cdr:sp macro="" textlink="">
      <cdr:nvSpPr>
        <cdr:cNvPr id="35" name="CasellaDiTesto 34"/>
        <cdr:cNvSpPr txBox="1"/>
      </cdr:nvSpPr>
      <cdr:spPr>
        <a:xfrm xmlns:a="http://schemas.openxmlformats.org/drawingml/2006/main" rot="16200000">
          <a:off x="4067227" y="1447781"/>
          <a:ext cx="476227" cy="41905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41246</cdr:x>
      <cdr:y>0.13254</cdr:y>
    </cdr:from>
    <cdr:to>
      <cdr:x>0.45052</cdr:x>
      <cdr:y>0.19284</cdr:y>
    </cdr:to>
    <cdr:sp macro="" textlink="">
      <cdr:nvSpPr>
        <cdr:cNvPr id="36" name="CasellaDiTesto 35"/>
        <cdr:cNvSpPr txBox="1"/>
      </cdr:nvSpPr>
      <cdr:spPr>
        <a:xfrm xmlns:a="http://schemas.openxmlformats.org/drawingml/2006/main" rot="16200000">
          <a:off x="4067082" y="1171612"/>
          <a:ext cx="504860" cy="38101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42721</cdr:x>
      <cdr:y>0.12856</cdr:y>
    </cdr:from>
    <cdr:to>
      <cdr:x>0.4529</cdr:x>
      <cdr:y>0.157</cdr:y>
    </cdr:to>
    <cdr:sp macro="" textlink="">
      <cdr:nvSpPr>
        <cdr:cNvPr id="37" name="CasellaDiTesto 36"/>
        <cdr:cNvSpPr txBox="1"/>
      </cdr:nvSpPr>
      <cdr:spPr>
        <a:xfrm xmlns:a="http://schemas.openxmlformats.org/drawingml/2006/main">
          <a:off x="4276721" y="1076385"/>
          <a:ext cx="257177" cy="2381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2435</cdr:x>
      <cdr:y>0.15017</cdr:y>
    </cdr:from>
    <cdr:to>
      <cdr:x>0.44243</cdr:x>
      <cdr:y>0.1843</cdr:y>
    </cdr:to>
    <cdr:sp macro="" textlink="">
      <cdr:nvSpPr>
        <cdr:cNvPr id="38" name="CasellaDiTesto 37"/>
        <cdr:cNvSpPr txBox="1"/>
      </cdr:nvSpPr>
      <cdr:spPr>
        <a:xfrm xmlns:a="http://schemas.openxmlformats.org/drawingml/2006/main">
          <a:off x="4248120" y="1257314"/>
          <a:ext cx="180995" cy="28575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5957</cdr:x>
      <cdr:y>0.27304</cdr:y>
    </cdr:from>
    <cdr:to>
      <cdr:x>0.47574</cdr:x>
      <cdr:y>0.30035</cdr:y>
    </cdr:to>
    <cdr:sp macro="" textlink="">
      <cdr:nvSpPr>
        <cdr:cNvPr id="39" name="CasellaDiTesto 38"/>
        <cdr:cNvSpPr txBox="1"/>
      </cdr:nvSpPr>
      <cdr:spPr>
        <a:xfrm xmlns:a="http://schemas.openxmlformats.org/drawingml/2006/main">
          <a:off x="4600614" y="2286026"/>
          <a:ext cx="161874" cy="2286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4548</cdr:x>
      <cdr:y>0.18544</cdr:y>
    </cdr:from>
    <cdr:to>
      <cdr:x>0.47193</cdr:x>
      <cdr:y>0.21843</cdr:y>
    </cdr:to>
    <cdr:sp macro="" textlink="">
      <cdr:nvSpPr>
        <cdr:cNvPr id="40" name="CasellaDiTesto 39"/>
        <cdr:cNvSpPr txBox="1"/>
      </cdr:nvSpPr>
      <cdr:spPr>
        <a:xfrm xmlns:a="http://schemas.openxmlformats.org/drawingml/2006/main">
          <a:off x="4552935" y="1552572"/>
          <a:ext cx="171485" cy="2762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46717</cdr:x>
      <cdr:y>0.14107</cdr:y>
    </cdr:from>
    <cdr:to>
      <cdr:x>0.49857</cdr:x>
      <cdr:y>0.18089</cdr:y>
    </cdr:to>
    <cdr:sp macro="" textlink="">
      <cdr:nvSpPr>
        <cdr:cNvPr id="41" name="CasellaDiTesto 40"/>
        <cdr:cNvSpPr txBox="1"/>
      </cdr:nvSpPr>
      <cdr:spPr>
        <a:xfrm xmlns:a="http://schemas.openxmlformats.org/drawingml/2006/main" rot="16200000">
          <a:off x="4667255" y="1190626"/>
          <a:ext cx="333392" cy="31433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c</a:t>
          </a:r>
        </a:p>
      </cdr:txBody>
    </cdr:sp>
  </cdr:relSizeAnchor>
  <cdr:relSizeAnchor xmlns:cdr="http://schemas.openxmlformats.org/drawingml/2006/chartDrawing">
    <cdr:from>
      <cdr:x>0.47668</cdr:x>
      <cdr:y>0.11945</cdr:y>
    </cdr:from>
    <cdr:to>
      <cdr:x>0.53282</cdr:x>
      <cdr:y>0.18202</cdr:y>
    </cdr:to>
    <cdr:sp macro="" textlink="">
      <cdr:nvSpPr>
        <cdr:cNvPr id="42" name="CasellaDiTesto 41"/>
        <cdr:cNvSpPr txBox="1"/>
      </cdr:nvSpPr>
      <cdr:spPr>
        <a:xfrm xmlns:a="http://schemas.openxmlformats.org/drawingml/2006/main" rot="16200000">
          <a:off x="4791024" y="981012"/>
          <a:ext cx="523865" cy="56200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c</a:t>
          </a:r>
        </a:p>
      </cdr:txBody>
    </cdr:sp>
  </cdr:relSizeAnchor>
  <cdr:relSizeAnchor xmlns:cdr="http://schemas.openxmlformats.org/drawingml/2006/chartDrawing">
    <cdr:from>
      <cdr:x>0.48763</cdr:x>
      <cdr:y>0.11547</cdr:y>
    </cdr:from>
    <cdr:to>
      <cdr:x>0.51998</cdr:x>
      <cdr:y>0.15984</cdr:y>
    </cdr:to>
    <cdr:sp macro="" textlink="">
      <cdr:nvSpPr>
        <cdr:cNvPr id="43" name="CasellaDiTesto 42"/>
        <cdr:cNvSpPr txBox="1"/>
      </cdr:nvSpPr>
      <cdr:spPr>
        <a:xfrm xmlns:a="http://schemas.openxmlformats.org/drawingml/2006/main" rot="16200000">
          <a:off x="4857712" y="990594"/>
          <a:ext cx="371487" cy="32384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51094</cdr:x>
      <cdr:y>0.37315</cdr:y>
    </cdr:from>
    <cdr:to>
      <cdr:x>0.53283</cdr:x>
      <cdr:y>0.41752</cdr:y>
    </cdr:to>
    <cdr:sp macro="" textlink="">
      <cdr:nvSpPr>
        <cdr:cNvPr id="44" name="CasellaDiTesto 43"/>
        <cdr:cNvSpPr txBox="1"/>
      </cdr:nvSpPr>
      <cdr:spPr>
        <a:xfrm xmlns:a="http://schemas.openxmlformats.org/drawingml/2006/main">
          <a:off x="5114909" y="3124203"/>
          <a:ext cx="219135" cy="37148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51855</cdr:x>
      <cdr:y>0.26166</cdr:y>
    </cdr:from>
    <cdr:to>
      <cdr:x>0.5509</cdr:x>
      <cdr:y>0.2992</cdr:y>
    </cdr:to>
    <cdr:sp macro="" textlink="">
      <cdr:nvSpPr>
        <cdr:cNvPr id="45" name="CasellaDiTesto 44"/>
        <cdr:cNvSpPr txBox="1"/>
      </cdr:nvSpPr>
      <cdr:spPr>
        <a:xfrm xmlns:a="http://schemas.openxmlformats.org/drawingml/2006/main">
          <a:off x="5191061" y="2190761"/>
          <a:ext cx="323849" cy="31430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 c </a:t>
          </a:r>
        </a:p>
      </cdr:txBody>
    </cdr:sp>
  </cdr:relSizeAnchor>
  <cdr:relSizeAnchor xmlns:cdr="http://schemas.openxmlformats.org/drawingml/2006/chartDrawing">
    <cdr:from>
      <cdr:x>0.53093</cdr:x>
      <cdr:y>0.23207</cdr:y>
    </cdr:from>
    <cdr:to>
      <cdr:x>0.55662</cdr:x>
      <cdr:y>0.28099</cdr:y>
    </cdr:to>
    <cdr:sp macro="" textlink="">
      <cdr:nvSpPr>
        <cdr:cNvPr id="46" name="CasellaDiTesto 45"/>
        <cdr:cNvSpPr txBox="1"/>
      </cdr:nvSpPr>
      <cdr:spPr>
        <a:xfrm xmlns:a="http://schemas.openxmlformats.org/drawingml/2006/main" rot="16200000">
          <a:off x="5238778" y="2019242"/>
          <a:ext cx="409581" cy="25717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c</a:t>
          </a:r>
        </a:p>
      </cdr:txBody>
    </cdr:sp>
  </cdr:relSizeAnchor>
  <cdr:relSizeAnchor xmlns:cdr="http://schemas.openxmlformats.org/drawingml/2006/chartDrawing">
    <cdr:from>
      <cdr:x>0.54044</cdr:x>
      <cdr:y>0.2173</cdr:y>
    </cdr:from>
    <cdr:to>
      <cdr:x>0.56137</cdr:x>
      <cdr:y>0.24688</cdr:y>
    </cdr:to>
    <cdr:sp macro="" textlink="">
      <cdr:nvSpPr>
        <cdr:cNvPr id="47" name="CasellaDiTesto 46"/>
        <cdr:cNvSpPr txBox="1"/>
      </cdr:nvSpPr>
      <cdr:spPr>
        <a:xfrm xmlns:a="http://schemas.openxmlformats.org/drawingml/2006/main">
          <a:off x="5410182" y="1819314"/>
          <a:ext cx="209526" cy="24765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57184</cdr:x>
      <cdr:y>0.12059</cdr:y>
    </cdr:from>
    <cdr:to>
      <cdr:x>0.59087</cdr:x>
      <cdr:y>0.1513</cdr:y>
    </cdr:to>
    <cdr:sp macro="" textlink="">
      <cdr:nvSpPr>
        <cdr:cNvPr id="48" name="CasellaDiTesto 47"/>
        <cdr:cNvSpPr txBox="1"/>
      </cdr:nvSpPr>
      <cdr:spPr>
        <a:xfrm xmlns:a="http://schemas.openxmlformats.org/drawingml/2006/main">
          <a:off x="5724517" y="1009676"/>
          <a:ext cx="190505" cy="2571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56708</cdr:x>
      <cdr:y>0.2446</cdr:y>
    </cdr:from>
    <cdr:to>
      <cdr:x>0.5842</cdr:x>
      <cdr:y>0.2719</cdr:y>
    </cdr:to>
    <cdr:sp macro="" textlink="">
      <cdr:nvSpPr>
        <cdr:cNvPr id="49" name="CasellaDiTesto 48"/>
        <cdr:cNvSpPr txBox="1"/>
      </cdr:nvSpPr>
      <cdr:spPr>
        <a:xfrm xmlns:a="http://schemas.openxmlformats.org/drawingml/2006/main">
          <a:off x="5676955" y="2047927"/>
          <a:ext cx="171384" cy="22856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57945</cdr:x>
      <cdr:y>0.04096</cdr:y>
    </cdr:from>
    <cdr:to>
      <cdr:x>0.60989</cdr:x>
      <cdr:y>0.08077</cdr:y>
    </cdr:to>
    <cdr:sp macro="" textlink="">
      <cdr:nvSpPr>
        <cdr:cNvPr id="51" name="CasellaDiTesto 50"/>
        <cdr:cNvSpPr txBox="1"/>
      </cdr:nvSpPr>
      <cdr:spPr>
        <a:xfrm xmlns:a="http://schemas.openxmlformats.org/drawingml/2006/main">
          <a:off x="5800749" y="342942"/>
          <a:ext cx="304728" cy="3333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9039</cdr:x>
      <cdr:y>0.0364</cdr:y>
    </cdr:from>
    <cdr:to>
      <cdr:x>0.63273</cdr:x>
      <cdr:y>0.10296</cdr:y>
    </cdr:to>
    <cdr:sp macro="" textlink="">
      <cdr:nvSpPr>
        <cdr:cNvPr id="52" name="CasellaDiTesto 51"/>
        <cdr:cNvSpPr txBox="1"/>
      </cdr:nvSpPr>
      <cdr:spPr>
        <a:xfrm xmlns:a="http://schemas.openxmlformats.org/drawingml/2006/main" rot="16200000">
          <a:off x="5843598" y="371477"/>
          <a:ext cx="557272" cy="42385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  <a:r>
            <a:rPr lang="fr-FR" sz="1000" baseline="0"/>
            <a:t> </a:t>
          </a:r>
          <a:endParaRPr lang="fr-FR" sz="1000"/>
        </a:p>
      </cdr:txBody>
    </cdr:sp>
  </cdr:relSizeAnchor>
  <cdr:relSizeAnchor xmlns:cdr="http://schemas.openxmlformats.org/drawingml/2006/chartDrawing">
    <cdr:from>
      <cdr:x>0.6099</cdr:x>
      <cdr:y>0.12855</cdr:y>
    </cdr:from>
    <cdr:to>
      <cdr:x>0.63749</cdr:x>
      <cdr:y>0.15927</cdr:y>
    </cdr:to>
    <cdr:sp macro="" textlink="">
      <cdr:nvSpPr>
        <cdr:cNvPr id="53" name="CasellaDiTesto 52"/>
        <cdr:cNvSpPr txBox="1"/>
      </cdr:nvSpPr>
      <cdr:spPr>
        <a:xfrm xmlns:a="http://schemas.openxmlformats.org/drawingml/2006/main">
          <a:off x="6105560" y="1076282"/>
          <a:ext cx="276197" cy="25720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238</cdr:x>
      <cdr:y>0.36313</cdr:y>
    </cdr:from>
    <cdr:to>
      <cdr:x>0.63903</cdr:x>
      <cdr:y>0.38929</cdr:y>
    </cdr:to>
    <cdr:sp macro="" textlink="">
      <cdr:nvSpPr>
        <cdr:cNvPr id="54" name="CasellaDiTesto 53"/>
        <cdr:cNvSpPr txBox="1"/>
      </cdr:nvSpPr>
      <cdr:spPr>
        <a:xfrm xmlns:a="http://schemas.openxmlformats.org/drawingml/2006/main">
          <a:off x="5704058" y="2549150"/>
          <a:ext cx="139263" cy="18364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63274</cdr:x>
      <cdr:y>0.21729</cdr:y>
    </cdr:from>
    <cdr:to>
      <cdr:x>0.65462</cdr:x>
      <cdr:y>0.24914</cdr:y>
    </cdr:to>
    <cdr:sp macro="" textlink="">
      <cdr:nvSpPr>
        <cdr:cNvPr id="55" name="CasellaDiTesto 54"/>
        <cdr:cNvSpPr txBox="1"/>
      </cdr:nvSpPr>
      <cdr:spPr>
        <a:xfrm xmlns:a="http://schemas.openxmlformats.org/drawingml/2006/main">
          <a:off x="6334177" y="1819275"/>
          <a:ext cx="219035" cy="2666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63273</cdr:x>
      <cdr:y>0.14335</cdr:y>
    </cdr:from>
    <cdr:to>
      <cdr:x>0.66604</cdr:x>
      <cdr:y>0.18999</cdr:y>
    </cdr:to>
    <cdr:sp macro="" textlink="">
      <cdr:nvSpPr>
        <cdr:cNvPr id="56" name="CasellaDiTesto 55"/>
        <cdr:cNvSpPr txBox="1"/>
      </cdr:nvSpPr>
      <cdr:spPr>
        <a:xfrm xmlns:a="http://schemas.openxmlformats.org/drawingml/2006/main" rot="16200000">
          <a:off x="6305563" y="1228691"/>
          <a:ext cx="390492" cy="33345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64257</cdr:x>
      <cdr:y>0.12097</cdr:y>
    </cdr:from>
    <cdr:to>
      <cdr:x>0.67587</cdr:x>
      <cdr:y>0.16761</cdr:y>
    </cdr:to>
    <cdr:sp macro="" textlink="">
      <cdr:nvSpPr>
        <cdr:cNvPr id="57" name="CasellaDiTesto 1"/>
        <cdr:cNvSpPr txBox="1"/>
      </cdr:nvSpPr>
      <cdr:spPr>
        <a:xfrm xmlns:a="http://schemas.openxmlformats.org/drawingml/2006/main" rot="16200000">
          <a:off x="6404017" y="1041385"/>
          <a:ext cx="390493" cy="33335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67206</cdr:x>
      <cdr:y>0.07319</cdr:y>
    </cdr:from>
    <cdr:to>
      <cdr:x>0.70536</cdr:x>
      <cdr:y>0.11983</cdr:y>
    </cdr:to>
    <cdr:sp macro="" textlink="">
      <cdr:nvSpPr>
        <cdr:cNvPr id="58" name="CasellaDiTesto 1"/>
        <cdr:cNvSpPr txBox="1"/>
      </cdr:nvSpPr>
      <cdr:spPr>
        <a:xfrm xmlns:a="http://schemas.openxmlformats.org/drawingml/2006/main" rot="16200000">
          <a:off x="6699250" y="641350"/>
          <a:ext cx="390525" cy="3333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fr-FR" sz="1000"/>
        </a:p>
      </cdr:txBody>
    </cdr:sp>
  </cdr:relSizeAnchor>
  <cdr:relSizeAnchor xmlns:cdr="http://schemas.openxmlformats.org/drawingml/2006/chartDrawing">
    <cdr:from>
      <cdr:x>0.7098</cdr:x>
      <cdr:y>0.08646</cdr:y>
    </cdr:from>
    <cdr:to>
      <cdr:x>0.73073</cdr:x>
      <cdr:y>0.12286</cdr:y>
    </cdr:to>
    <cdr:sp macro="" textlink="">
      <cdr:nvSpPr>
        <cdr:cNvPr id="59" name="CasellaDiTesto 58"/>
        <cdr:cNvSpPr txBox="1"/>
      </cdr:nvSpPr>
      <cdr:spPr>
        <a:xfrm xmlns:a="http://schemas.openxmlformats.org/drawingml/2006/main">
          <a:off x="7105655" y="723912"/>
          <a:ext cx="209525" cy="30475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7459</cdr:x>
      <cdr:y>0.30603</cdr:y>
    </cdr:from>
    <cdr:to>
      <cdr:x>0.69172</cdr:x>
      <cdr:y>0.34358</cdr:y>
    </cdr:to>
    <cdr:sp macro="" textlink="">
      <cdr:nvSpPr>
        <cdr:cNvPr id="60" name="CasellaDiTesto 59"/>
        <cdr:cNvSpPr txBox="1"/>
      </cdr:nvSpPr>
      <cdr:spPr>
        <a:xfrm xmlns:a="http://schemas.openxmlformats.org/drawingml/2006/main">
          <a:off x="6753210" y="2562209"/>
          <a:ext cx="171484" cy="3143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68411</cdr:x>
      <cdr:y>0.18544</cdr:y>
    </cdr:from>
    <cdr:to>
      <cdr:x>0.72312</cdr:x>
      <cdr:y>0.23208</cdr:y>
    </cdr:to>
    <cdr:sp macro="" textlink="">
      <cdr:nvSpPr>
        <cdr:cNvPr id="61" name="CasellaDiTesto 60"/>
        <cdr:cNvSpPr txBox="1"/>
      </cdr:nvSpPr>
      <cdr:spPr>
        <a:xfrm xmlns:a="http://schemas.openxmlformats.org/drawingml/2006/main" rot="16200000">
          <a:off x="6848446" y="1552583"/>
          <a:ext cx="390492" cy="3905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69362</cdr:x>
      <cdr:y>0.1149</cdr:y>
    </cdr:from>
    <cdr:to>
      <cdr:x>0.73644</cdr:x>
      <cdr:y>0.15244</cdr:y>
    </cdr:to>
    <cdr:sp macro="" textlink="">
      <cdr:nvSpPr>
        <cdr:cNvPr id="62" name="CasellaDiTesto 61"/>
        <cdr:cNvSpPr txBox="1"/>
      </cdr:nvSpPr>
      <cdr:spPr>
        <a:xfrm xmlns:a="http://schemas.openxmlformats.org/drawingml/2006/main">
          <a:off x="6943690" y="962022"/>
          <a:ext cx="428662" cy="31430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 a</a:t>
          </a:r>
        </a:p>
      </cdr:txBody>
    </cdr:sp>
  </cdr:relSizeAnchor>
  <cdr:relSizeAnchor xmlns:cdr="http://schemas.openxmlformats.org/drawingml/2006/chartDrawing">
    <cdr:from>
      <cdr:x>0.71836</cdr:x>
      <cdr:y>0.12855</cdr:y>
    </cdr:from>
    <cdr:to>
      <cdr:x>0.75547</cdr:x>
      <cdr:y>0.16041</cdr:y>
    </cdr:to>
    <cdr:sp macro="" textlink="">
      <cdr:nvSpPr>
        <cdr:cNvPr id="63" name="CasellaDiTesto 62"/>
        <cdr:cNvSpPr txBox="1"/>
      </cdr:nvSpPr>
      <cdr:spPr>
        <a:xfrm xmlns:a="http://schemas.openxmlformats.org/drawingml/2006/main" rot="10800000" flipV="1">
          <a:off x="7191375" y="1076310"/>
          <a:ext cx="371476" cy="26671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77355</cdr:x>
      <cdr:y>0.13311</cdr:y>
    </cdr:from>
    <cdr:to>
      <cdr:x>0.80685</cdr:x>
      <cdr:y>0.16496</cdr:y>
    </cdr:to>
    <cdr:sp macro="" textlink="">
      <cdr:nvSpPr>
        <cdr:cNvPr id="64" name="CasellaDiTesto 63"/>
        <cdr:cNvSpPr txBox="1"/>
      </cdr:nvSpPr>
      <cdr:spPr>
        <a:xfrm xmlns:a="http://schemas.openxmlformats.org/drawingml/2006/main">
          <a:off x="7743791" y="1114421"/>
          <a:ext cx="333359" cy="2666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73359</cdr:x>
      <cdr:y>0.38681</cdr:y>
    </cdr:from>
    <cdr:to>
      <cdr:x>0.75262</cdr:x>
      <cdr:y>0.41411</cdr:y>
    </cdr:to>
    <cdr:sp macro="" textlink="">
      <cdr:nvSpPr>
        <cdr:cNvPr id="65" name="CasellaDiTesto 64"/>
        <cdr:cNvSpPr txBox="1"/>
      </cdr:nvSpPr>
      <cdr:spPr>
        <a:xfrm xmlns:a="http://schemas.openxmlformats.org/drawingml/2006/main">
          <a:off x="7343845" y="3238557"/>
          <a:ext cx="190506" cy="22856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73644</cdr:x>
      <cdr:y>0.17065</cdr:y>
    </cdr:from>
    <cdr:to>
      <cdr:x>0.76118</cdr:x>
      <cdr:y>0.21616</cdr:y>
    </cdr:to>
    <cdr:sp macro="" textlink="">
      <cdr:nvSpPr>
        <cdr:cNvPr id="66" name="CasellaDiTesto 65"/>
        <cdr:cNvSpPr txBox="1"/>
      </cdr:nvSpPr>
      <cdr:spPr>
        <a:xfrm xmlns:a="http://schemas.openxmlformats.org/drawingml/2006/main">
          <a:off x="7372332" y="1428763"/>
          <a:ext cx="247666" cy="38103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76784</cdr:x>
      <cdr:y>0.1058</cdr:y>
    </cdr:from>
    <cdr:to>
      <cdr:x>0.79068</cdr:x>
      <cdr:y>0.13197</cdr:y>
    </cdr:to>
    <cdr:sp macro="" textlink="">
      <cdr:nvSpPr>
        <cdr:cNvPr id="67" name="CasellaDiTesto 66"/>
        <cdr:cNvSpPr txBox="1"/>
      </cdr:nvSpPr>
      <cdr:spPr>
        <a:xfrm xmlns:a="http://schemas.openxmlformats.org/drawingml/2006/main">
          <a:off x="7686631" y="885827"/>
          <a:ext cx="228646" cy="2191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74198</cdr:x>
      <cdr:y>0.0858</cdr:y>
    </cdr:from>
    <cdr:to>
      <cdr:x>0.7924</cdr:x>
      <cdr:y>0.14724</cdr:y>
    </cdr:to>
    <cdr:sp macro="" textlink="">
      <cdr:nvSpPr>
        <cdr:cNvPr id="68" name="CasellaDiTesto 67"/>
        <cdr:cNvSpPr txBox="1"/>
      </cdr:nvSpPr>
      <cdr:spPr>
        <a:xfrm xmlns:a="http://schemas.openxmlformats.org/drawingml/2006/main" rot="16200000">
          <a:off x="6799500" y="587455"/>
          <a:ext cx="431309" cy="4610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 </a:t>
          </a:r>
        </a:p>
        <a:p xmlns:a="http://schemas.openxmlformats.org/drawingml/2006/main">
          <a:r>
            <a:rPr lang="fr-FR" sz="1000"/>
            <a:t> ab</a:t>
          </a:r>
        </a:p>
      </cdr:txBody>
    </cdr:sp>
  </cdr:relSizeAnchor>
  <cdr:relSizeAnchor xmlns:cdr="http://schemas.openxmlformats.org/drawingml/2006/chartDrawing">
    <cdr:from>
      <cdr:x>0.82873</cdr:x>
      <cdr:y>0.12856</cdr:y>
    </cdr:from>
    <cdr:to>
      <cdr:x>0.85157</cdr:x>
      <cdr:y>0.16041</cdr:y>
    </cdr:to>
    <cdr:sp macro="" textlink="">
      <cdr:nvSpPr>
        <cdr:cNvPr id="69" name="CasellaDiTesto 68"/>
        <cdr:cNvSpPr txBox="1"/>
      </cdr:nvSpPr>
      <cdr:spPr>
        <a:xfrm xmlns:a="http://schemas.openxmlformats.org/drawingml/2006/main">
          <a:off x="8296256" y="1076346"/>
          <a:ext cx="228646" cy="2666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78783</cdr:x>
      <cdr:y>0.3777</cdr:y>
    </cdr:from>
    <cdr:to>
      <cdr:x>0.81352</cdr:x>
      <cdr:y>0.41183</cdr:y>
    </cdr:to>
    <cdr:sp macro="" textlink="">
      <cdr:nvSpPr>
        <cdr:cNvPr id="70" name="CasellaDiTesto 69"/>
        <cdr:cNvSpPr txBox="1"/>
      </cdr:nvSpPr>
      <cdr:spPr>
        <a:xfrm xmlns:a="http://schemas.openxmlformats.org/drawingml/2006/main">
          <a:off x="7886771" y="3162284"/>
          <a:ext cx="257177" cy="2857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79733</cdr:x>
      <cdr:y>0.20022</cdr:y>
    </cdr:from>
    <cdr:to>
      <cdr:x>0.82778</cdr:x>
      <cdr:y>0.23208</cdr:y>
    </cdr:to>
    <cdr:sp macro="" textlink="">
      <cdr:nvSpPr>
        <cdr:cNvPr id="71" name="CasellaDiTesto 70"/>
        <cdr:cNvSpPr txBox="1"/>
      </cdr:nvSpPr>
      <cdr:spPr>
        <a:xfrm xmlns:a="http://schemas.openxmlformats.org/drawingml/2006/main">
          <a:off x="7981932" y="1676337"/>
          <a:ext cx="304828" cy="26674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80352</cdr:x>
      <cdr:y>0.12457</cdr:y>
    </cdr:from>
    <cdr:to>
      <cdr:x>0.82873</cdr:x>
      <cdr:y>0.18828</cdr:y>
    </cdr:to>
    <cdr:sp macro="" textlink="">
      <cdr:nvSpPr>
        <cdr:cNvPr id="72" name="CasellaDiTesto 71"/>
        <cdr:cNvSpPr txBox="1"/>
      </cdr:nvSpPr>
      <cdr:spPr>
        <a:xfrm xmlns:a="http://schemas.openxmlformats.org/drawingml/2006/main" rot="16200000">
          <a:off x="7903295" y="1183459"/>
          <a:ext cx="533410" cy="25237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 </a:t>
          </a:r>
        </a:p>
      </cdr:txBody>
    </cdr:sp>
  </cdr:relSizeAnchor>
  <cdr:relSizeAnchor xmlns:cdr="http://schemas.openxmlformats.org/drawingml/2006/chartDrawing">
    <cdr:from>
      <cdr:x>0.81256</cdr:x>
      <cdr:y>0.14334</cdr:y>
    </cdr:from>
    <cdr:to>
      <cdr:x>0.85062</cdr:x>
      <cdr:y>0.19567</cdr:y>
    </cdr:to>
    <cdr:sp macro="" textlink="">
      <cdr:nvSpPr>
        <cdr:cNvPr id="73" name="CasellaDiTesto 72"/>
        <cdr:cNvSpPr txBox="1"/>
      </cdr:nvSpPr>
      <cdr:spPr>
        <a:xfrm xmlns:a="http://schemas.openxmlformats.org/drawingml/2006/main" rot="16200000">
          <a:off x="8105835" y="1228672"/>
          <a:ext cx="438131" cy="3810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81684</cdr:x>
      <cdr:y>0.13139</cdr:y>
    </cdr:from>
    <cdr:to>
      <cdr:x>0.85204</cdr:x>
      <cdr:y>0.17462</cdr:y>
    </cdr:to>
    <cdr:sp macro="" textlink="">
      <cdr:nvSpPr>
        <cdr:cNvPr id="74" name="CasellaDiTesto 73"/>
        <cdr:cNvSpPr txBox="1"/>
      </cdr:nvSpPr>
      <cdr:spPr>
        <a:xfrm xmlns:a="http://schemas.openxmlformats.org/drawingml/2006/main" rot="16200000">
          <a:off x="8172462" y="1104880"/>
          <a:ext cx="361942" cy="35237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85</cdr:x>
      <cdr:y>0.15197</cdr:y>
    </cdr:from>
    <cdr:to>
      <cdr:x>0.88799</cdr:x>
      <cdr:y>0.18605</cdr:y>
    </cdr:to>
    <cdr:sp macro="" textlink="">
      <cdr:nvSpPr>
        <cdr:cNvPr id="75" name="CasellaDiTesto 74"/>
        <cdr:cNvSpPr txBox="1"/>
      </cdr:nvSpPr>
      <cdr:spPr>
        <a:xfrm xmlns:a="http://schemas.openxmlformats.org/drawingml/2006/main">
          <a:off x="7772401" y="1066800"/>
          <a:ext cx="347425" cy="23930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100"/>
            <a:t>a</a:t>
          </a:r>
        </a:p>
      </cdr:txBody>
    </cdr:sp>
  </cdr:relSizeAnchor>
  <cdr:relSizeAnchor xmlns:cdr="http://schemas.openxmlformats.org/drawingml/2006/chartDrawing">
    <cdr:from>
      <cdr:x>0.84681</cdr:x>
      <cdr:y>0.30831</cdr:y>
    </cdr:from>
    <cdr:to>
      <cdr:x>0.86108</cdr:x>
      <cdr:y>0.33561</cdr:y>
    </cdr:to>
    <cdr:sp macro="" textlink="">
      <cdr:nvSpPr>
        <cdr:cNvPr id="76" name="CasellaDiTesto 75"/>
        <cdr:cNvSpPr txBox="1"/>
      </cdr:nvSpPr>
      <cdr:spPr>
        <a:xfrm xmlns:a="http://schemas.openxmlformats.org/drawingml/2006/main">
          <a:off x="8477206" y="2581323"/>
          <a:ext cx="142854" cy="22856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87441</cdr:x>
      <cdr:y>0.1058</cdr:y>
    </cdr:from>
    <cdr:to>
      <cdr:x>0.89724</cdr:x>
      <cdr:y>0.13538</cdr:y>
    </cdr:to>
    <cdr:sp macro="" textlink="">
      <cdr:nvSpPr>
        <cdr:cNvPr id="77" name="CasellaDiTesto 76"/>
        <cdr:cNvSpPr txBox="1"/>
      </cdr:nvSpPr>
      <cdr:spPr>
        <a:xfrm xmlns:a="http://schemas.openxmlformats.org/drawingml/2006/main">
          <a:off x="8753510" y="885774"/>
          <a:ext cx="228546" cy="24765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86109</cdr:x>
      <cdr:y>0.10125</cdr:y>
    </cdr:from>
    <cdr:to>
      <cdr:x>0.89439</cdr:x>
      <cdr:y>0.14562</cdr:y>
    </cdr:to>
    <cdr:sp macro="" textlink="">
      <cdr:nvSpPr>
        <cdr:cNvPr id="78" name="CasellaDiTesto 77"/>
        <cdr:cNvSpPr txBox="1"/>
      </cdr:nvSpPr>
      <cdr:spPr>
        <a:xfrm xmlns:a="http://schemas.openxmlformats.org/drawingml/2006/main">
          <a:off x="8620139" y="847708"/>
          <a:ext cx="333359" cy="37148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8668</cdr:x>
      <cdr:y>0.15244</cdr:y>
    </cdr:from>
    <cdr:to>
      <cdr:x>0.89629</cdr:x>
      <cdr:y>0.17633</cdr:y>
    </cdr:to>
    <cdr:sp macro="" textlink="">
      <cdr:nvSpPr>
        <cdr:cNvPr id="79" name="CasellaDiTesto 78"/>
        <cdr:cNvSpPr txBox="1"/>
      </cdr:nvSpPr>
      <cdr:spPr>
        <a:xfrm xmlns:a="http://schemas.openxmlformats.org/drawingml/2006/main">
          <a:off x="8677322" y="1276300"/>
          <a:ext cx="295218" cy="2000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9685</cdr:x>
      <cdr:y>0.12921</cdr:y>
    </cdr:from>
    <cdr:to>
      <cdr:x>0.51778</cdr:x>
      <cdr:y>0.15424</cdr:y>
    </cdr:to>
    <cdr:sp macro="" textlink="">
      <cdr:nvSpPr>
        <cdr:cNvPr id="80" name="CasellaDiTesto 79"/>
        <cdr:cNvSpPr txBox="1"/>
      </cdr:nvSpPr>
      <cdr:spPr>
        <a:xfrm xmlns:a="http://schemas.openxmlformats.org/drawingml/2006/main">
          <a:off x="4543227" y="907058"/>
          <a:ext cx="191384" cy="1757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1884</cdr:x>
      <cdr:y>0.13083</cdr:y>
    </cdr:from>
    <cdr:to>
      <cdr:x>0.23692</cdr:x>
      <cdr:y>0.15927</cdr:y>
    </cdr:to>
    <cdr:sp macro="" textlink="">
      <cdr:nvSpPr>
        <cdr:cNvPr id="81" name="TextBox 80">
          <a:extLst xmlns:a="http://schemas.openxmlformats.org/drawingml/2006/main">
            <a:ext uri="{FF2B5EF4-FFF2-40B4-BE49-F238E27FC236}">
              <a16:creationId xmlns="" xmlns:a16="http://schemas.microsoft.com/office/drawing/2014/main" id="{BD8718A6-0CDB-4DAB-B675-0EE421BD3A76}"/>
            </a:ext>
          </a:extLst>
        </cdr:cNvPr>
        <cdr:cNvSpPr txBox="1"/>
      </cdr:nvSpPr>
      <cdr:spPr>
        <a:xfrm xmlns:a="http://schemas.openxmlformats.org/drawingml/2006/main">
          <a:off x="2190753" y="1095371"/>
          <a:ext cx="180995" cy="2381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3863</cdr:x>
      <cdr:y>0.12856</cdr:y>
    </cdr:from>
    <cdr:to>
      <cdr:x>0.45956</cdr:x>
      <cdr:y>0.15359</cdr:y>
    </cdr:to>
    <cdr:sp macro="" textlink="">
      <cdr:nvSpPr>
        <cdr:cNvPr id="82" name="TextBox 81">
          <a:extLst xmlns:a="http://schemas.openxmlformats.org/drawingml/2006/main">
            <a:ext uri="{FF2B5EF4-FFF2-40B4-BE49-F238E27FC236}">
              <a16:creationId xmlns="" xmlns:a16="http://schemas.microsoft.com/office/drawing/2014/main" id="{759D98BD-6B28-4FD2-A59A-C28A96105C8F}"/>
            </a:ext>
          </a:extLst>
        </cdr:cNvPr>
        <cdr:cNvSpPr txBox="1"/>
      </cdr:nvSpPr>
      <cdr:spPr>
        <a:xfrm xmlns:a="http://schemas.openxmlformats.org/drawingml/2006/main">
          <a:off x="4391059" y="1076346"/>
          <a:ext cx="209526" cy="2095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4841</cdr:x>
      <cdr:y>0.13105</cdr:y>
    </cdr:from>
    <cdr:to>
      <cdr:x>0.57125</cdr:x>
      <cdr:y>0.16746</cdr:y>
    </cdr:to>
    <cdr:sp macro="" textlink="">
      <cdr:nvSpPr>
        <cdr:cNvPr id="83" name="TextBox 82">
          <a:extLst xmlns:a="http://schemas.openxmlformats.org/drawingml/2006/main">
            <a:ext uri="{FF2B5EF4-FFF2-40B4-BE49-F238E27FC236}">
              <a16:creationId xmlns="" xmlns:a16="http://schemas.microsoft.com/office/drawing/2014/main" id="{C8E99514-3D0D-437B-9E82-749F738422A4}"/>
            </a:ext>
          </a:extLst>
        </cdr:cNvPr>
        <cdr:cNvSpPr txBox="1"/>
      </cdr:nvSpPr>
      <cdr:spPr>
        <a:xfrm xmlns:a="http://schemas.openxmlformats.org/drawingml/2006/main">
          <a:off x="5014631" y="919949"/>
          <a:ext cx="208849" cy="25559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9848</cdr:x>
      <cdr:y>0.02502</cdr:y>
    </cdr:from>
    <cdr:to>
      <cdr:x>0.64891</cdr:x>
      <cdr:y>0.0967</cdr:y>
    </cdr:to>
    <cdr:sp macro="" textlink="">
      <cdr:nvSpPr>
        <cdr:cNvPr id="84" name="TextBox 83">
          <a:extLst xmlns:a="http://schemas.openxmlformats.org/drawingml/2006/main">
            <a:ext uri="{FF2B5EF4-FFF2-40B4-BE49-F238E27FC236}">
              <a16:creationId xmlns="" xmlns:a16="http://schemas.microsoft.com/office/drawing/2014/main" id="{DEDAFE45-8AC6-4224-AFDF-B1A56B54FF81}"/>
            </a:ext>
          </a:extLst>
        </cdr:cNvPr>
        <cdr:cNvSpPr txBox="1"/>
      </cdr:nvSpPr>
      <cdr:spPr>
        <a:xfrm xmlns:a="http://schemas.openxmlformats.org/drawingml/2006/main" rot="16200000">
          <a:off x="5943560" y="257168"/>
          <a:ext cx="600139" cy="50484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64938</cdr:x>
      <cdr:y>0.06485</cdr:y>
    </cdr:from>
    <cdr:to>
      <cdr:x>0.6922</cdr:x>
      <cdr:y>0.11775</cdr:y>
    </cdr:to>
    <cdr:sp macro="" textlink="">
      <cdr:nvSpPr>
        <cdr:cNvPr id="85" name="TextBox 84">
          <a:extLst xmlns:a="http://schemas.openxmlformats.org/drawingml/2006/main">
            <a:ext uri="{FF2B5EF4-FFF2-40B4-BE49-F238E27FC236}">
              <a16:creationId xmlns="" xmlns:a16="http://schemas.microsoft.com/office/drawing/2014/main" id="{F2CD762D-54D7-44CD-9799-97E69CEE352A}"/>
            </a:ext>
          </a:extLst>
        </cdr:cNvPr>
        <cdr:cNvSpPr txBox="1"/>
      </cdr:nvSpPr>
      <cdr:spPr>
        <a:xfrm xmlns:a="http://schemas.openxmlformats.org/drawingml/2006/main" rot="16200000">
          <a:off x="6493670" y="550069"/>
          <a:ext cx="442913" cy="4286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66032</cdr:x>
      <cdr:y>0.12969</cdr:y>
    </cdr:from>
    <cdr:to>
      <cdr:x>0.68221</cdr:x>
      <cdr:y>0.17065</cdr:y>
    </cdr:to>
    <cdr:sp macro="" textlink="">
      <cdr:nvSpPr>
        <cdr:cNvPr id="86" name="TextBox 85">
          <a:extLst xmlns:a="http://schemas.openxmlformats.org/drawingml/2006/main">
            <a:ext uri="{FF2B5EF4-FFF2-40B4-BE49-F238E27FC236}">
              <a16:creationId xmlns="" xmlns:a16="http://schemas.microsoft.com/office/drawing/2014/main" id="{1FCBAAA2-53DE-4840-970A-3BE9BE6971D9}"/>
            </a:ext>
          </a:extLst>
        </cdr:cNvPr>
        <cdr:cNvSpPr txBox="1"/>
      </cdr:nvSpPr>
      <cdr:spPr>
        <a:xfrm xmlns:a="http://schemas.openxmlformats.org/drawingml/2006/main">
          <a:off x="6610351" y="1085850"/>
          <a:ext cx="219075" cy="3429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88297</cdr:x>
      <cdr:y>0.12856</cdr:y>
    </cdr:from>
    <cdr:to>
      <cdr:x>0.90486</cdr:x>
      <cdr:y>0.16041</cdr:y>
    </cdr:to>
    <cdr:sp macro="" textlink="">
      <cdr:nvSpPr>
        <cdr:cNvPr id="87" name="TextBox 86">
          <a:extLst xmlns:a="http://schemas.openxmlformats.org/drawingml/2006/main">
            <a:ext uri="{FF2B5EF4-FFF2-40B4-BE49-F238E27FC236}">
              <a16:creationId xmlns="" xmlns:a16="http://schemas.microsoft.com/office/drawing/2014/main" id="{0F9EC9A7-FA94-4402-BC0E-7940AC6E830C}"/>
            </a:ext>
          </a:extLst>
        </cdr:cNvPr>
        <cdr:cNvSpPr txBox="1"/>
      </cdr:nvSpPr>
      <cdr:spPr>
        <a:xfrm xmlns:a="http://schemas.openxmlformats.org/drawingml/2006/main">
          <a:off x="8839181" y="1076346"/>
          <a:ext cx="219136" cy="2666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3796</cdr:x>
      <cdr:y>0.17502</cdr:y>
    </cdr:from>
    <cdr:to>
      <cdr:x>0.25313</cdr:x>
      <cdr:y>0.2076</cdr:y>
    </cdr:to>
    <cdr:sp macro="" textlink="">
      <cdr:nvSpPr>
        <cdr:cNvPr id="6" name="CasellaDiTesto 5"/>
        <cdr:cNvSpPr txBox="1"/>
      </cdr:nvSpPr>
      <cdr:spPr>
        <a:xfrm xmlns:a="http://schemas.openxmlformats.org/drawingml/2006/main">
          <a:off x="2175921" y="1228633"/>
          <a:ext cx="138655" cy="22869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GB" sz="1100"/>
            <a:t>a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/>
          <p:cNvSpPr/>
          <p:nvPr/>
        </p:nvSpPr>
        <p:spPr>
          <a:xfrm>
            <a:off x="6234340" y="12464"/>
            <a:ext cx="215559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smtClean="0"/>
              <a:t>Honokiol</a:t>
            </a:r>
            <a:r>
              <a:rPr lang="en-GB" b="1" dirty="0" smtClean="0"/>
              <a:t> </a:t>
            </a:r>
            <a:r>
              <a:rPr lang="en-GB" b="1" dirty="0"/>
              <a:t>diacetate </a:t>
            </a:r>
            <a:r>
              <a:rPr lang="en-GB" b="1" dirty="0" smtClean="0"/>
              <a:t>7</a:t>
            </a:r>
            <a:endParaRPr lang="en-GB" b="1" dirty="0"/>
          </a:p>
        </p:txBody>
      </p:sp>
      <p:graphicFrame>
        <p:nvGraphicFramePr>
          <p:cNvPr id="5" name="Grafico 4">
            <a:extLst>
              <a:ext uri="{FF2B5EF4-FFF2-40B4-BE49-F238E27FC236}">
                <a16:creationId xmlns:lc="http://schemas.openxmlformats.org/drawingml/2006/lockedCanvas" xmlns="" xmlns:a16="http://schemas.microsoft.com/office/drawing/2014/main" xmlns:xdr="http://schemas.openxmlformats.org/drawingml/2006/spreadsheetDrawing" id="{00000000-0008-0000-04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93423567"/>
              </p:ext>
            </p:extLst>
          </p:nvPr>
        </p:nvGraphicFramePr>
        <p:xfrm>
          <a:off x="107504" y="-147"/>
          <a:ext cx="8568952" cy="65266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5711379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5</TotalTime>
  <Words>101</Words>
  <Application>Microsoft Office PowerPoint</Application>
  <PresentationFormat>Presentazione su schermo (4:3)</PresentationFormat>
  <Paragraphs>8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fa oufensou</dc:creator>
  <cp:lastModifiedBy>Vanna Delogu</cp:lastModifiedBy>
  <cp:revision>54</cp:revision>
  <dcterms:created xsi:type="dcterms:W3CDTF">2019-06-04T18:45:56Z</dcterms:created>
  <dcterms:modified xsi:type="dcterms:W3CDTF">2019-08-20T09:28:17Z</dcterms:modified>
</cp:coreProperties>
</file>